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3"/>
  </p:notesMasterIdLst>
  <p:sldIdLst>
    <p:sldId id="288" r:id="rId5"/>
    <p:sldId id="263" r:id="rId6"/>
    <p:sldId id="281" r:id="rId7"/>
    <p:sldId id="282" r:id="rId8"/>
    <p:sldId id="276" r:id="rId9"/>
    <p:sldId id="283" r:id="rId10"/>
    <p:sldId id="290" r:id="rId11"/>
    <p:sldId id="289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FE8F5"/>
    <a:srgbClr val="F0F4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A41CAE-FB9F-41C0-B3FF-4F4F7BC35C32}" v="52" dt="2024-03-13T16:03:06.59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94" autoAdjust="0"/>
    <p:restoredTop sz="93451" autoAdjust="0"/>
  </p:normalViewPr>
  <p:slideViewPr>
    <p:cSldViewPr snapToGrid="0">
      <p:cViewPr varScale="1">
        <p:scale>
          <a:sx n="74" d="100"/>
          <a:sy n="74" d="100"/>
        </p:scale>
        <p:origin x="960" y="72"/>
      </p:cViewPr>
      <p:guideLst/>
    </p:cSldViewPr>
  </p:slideViewPr>
  <p:notesTextViewPr>
    <p:cViewPr>
      <p:scale>
        <a:sx n="1" d="1"/>
        <a:sy n="1" d="1"/>
      </p:scale>
      <p:origin x="0" y="-354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onnor Blair" userId="5dffaaf1-4e99-4a9f-9d58-f6e2d8990ba3" providerId="ADAL" clId="{8FA41CAE-FB9F-41C0-B3FF-4F4F7BC35C32}"/>
    <pc:docChg chg="undo custSel addSld modSld sldOrd">
      <pc:chgData name="Connor Blair" userId="5dffaaf1-4e99-4a9f-9d58-f6e2d8990ba3" providerId="ADAL" clId="{8FA41CAE-FB9F-41C0-B3FF-4F4F7BC35C32}" dt="2024-03-14T17:49:49.658" v="719" actId="114"/>
      <pc:docMkLst>
        <pc:docMk/>
      </pc:docMkLst>
      <pc:sldChg chg="modSp">
        <pc:chgData name="Connor Blair" userId="5dffaaf1-4e99-4a9f-9d58-f6e2d8990ba3" providerId="ADAL" clId="{8FA41CAE-FB9F-41C0-B3FF-4F4F7BC35C32}" dt="2024-03-13T16:03:06.595" v="653"/>
        <pc:sldMkLst>
          <pc:docMk/>
          <pc:sldMk cId="1032784987" sldId="276"/>
        </pc:sldMkLst>
        <pc:graphicFrameChg chg="mod">
          <ac:chgData name="Connor Blair" userId="5dffaaf1-4e99-4a9f-9d58-f6e2d8990ba3" providerId="ADAL" clId="{8FA41CAE-FB9F-41C0-B3FF-4F4F7BC35C32}" dt="2024-03-13T16:03:06.595" v="653"/>
          <ac:graphicFrameMkLst>
            <pc:docMk/>
            <pc:sldMk cId="1032784987" sldId="276"/>
            <ac:graphicFrameMk id="5" creationId="{FC6CFF32-68BC-B007-09C2-E0DB2065DE5C}"/>
          </ac:graphicFrameMkLst>
        </pc:graphicFrameChg>
        <pc:graphicFrameChg chg="mod">
          <ac:chgData name="Connor Blair" userId="5dffaaf1-4e99-4a9f-9d58-f6e2d8990ba3" providerId="ADAL" clId="{8FA41CAE-FB9F-41C0-B3FF-4F4F7BC35C32}" dt="2024-03-13T16:03:05.686" v="652"/>
          <ac:graphicFrameMkLst>
            <pc:docMk/>
            <pc:sldMk cId="1032784987" sldId="276"/>
            <ac:graphicFrameMk id="22" creationId="{FE69B9D4-0D92-5C18-9201-104B5EE1BAB2}"/>
          </ac:graphicFrameMkLst>
        </pc:graphicFrameChg>
        <pc:graphicFrameChg chg="mod">
          <ac:chgData name="Connor Blair" userId="5dffaaf1-4e99-4a9f-9d58-f6e2d8990ba3" providerId="ADAL" clId="{8FA41CAE-FB9F-41C0-B3FF-4F4F7BC35C32}" dt="2024-03-13T16:03:04.369" v="651"/>
          <ac:graphicFrameMkLst>
            <pc:docMk/>
            <pc:sldMk cId="1032784987" sldId="276"/>
            <ac:graphicFrameMk id="23" creationId="{9698A734-38EB-2EAF-8AD9-7BB209293BB5}"/>
          </ac:graphicFrameMkLst>
        </pc:graphicFrameChg>
        <pc:graphicFrameChg chg="mod">
          <ac:chgData name="Connor Blair" userId="5dffaaf1-4e99-4a9f-9d58-f6e2d8990ba3" providerId="ADAL" clId="{8FA41CAE-FB9F-41C0-B3FF-4F4F7BC35C32}" dt="2024-03-13T16:03:03.280" v="650"/>
          <ac:graphicFrameMkLst>
            <pc:docMk/>
            <pc:sldMk cId="1032784987" sldId="276"/>
            <ac:graphicFrameMk id="25" creationId="{55BF5F2E-C383-495E-9B46-82A4B67B8B9A}"/>
          </ac:graphicFrameMkLst>
        </pc:graphicFrameChg>
      </pc:sldChg>
      <pc:sldChg chg="addSp modSp mod modNotesTx">
        <pc:chgData name="Connor Blair" userId="5dffaaf1-4e99-4a9f-9d58-f6e2d8990ba3" providerId="ADAL" clId="{8FA41CAE-FB9F-41C0-B3FF-4F4F7BC35C32}" dt="2024-03-14T17:49:22.924" v="659" actId="20577"/>
        <pc:sldMkLst>
          <pc:docMk/>
          <pc:sldMk cId="1278895754" sldId="289"/>
        </pc:sldMkLst>
        <pc:spChg chg="add mod">
          <ac:chgData name="Connor Blair" userId="5dffaaf1-4e99-4a9f-9d58-f6e2d8990ba3" providerId="ADAL" clId="{8FA41CAE-FB9F-41C0-B3FF-4F4F7BC35C32}" dt="2024-03-12T13:10:41.008" v="220" actId="1035"/>
          <ac:spMkLst>
            <pc:docMk/>
            <pc:sldMk cId="1278895754" sldId="289"/>
            <ac:spMk id="2" creationId="{A68BEB47-DDD4-F3FD-A253-A13E28FE38BE}"/>
          </ac:spMkLst>
        </pc:spChg>
        <pc:spChg chg="mod">
          <ac:chgData name="Connor Blair" userId="5dffaaf1-4e99-4a9f-9d58-f6e2d8990ba3" providerId="ADAL" clId="{8FA41CAE-FB9F-41C0-B3FF-4F4F7BC35C32}" dt="2024-03-14T17:49:20.970" v="657" actId="20577"/>
          <ac:spMkLst>
            <pc:docMk/>
            <pc:sldMk cId="1278895754" sldId="289"/>
            <ac:spMk id="4" creationId="{EF41DF83-CFF1-209E-DF27-D250131B4B2D}"/>
          </ac:spMkLst>
        </pc:spChg>
        <pc:graphicFrameChg chg="mod">
          <ac:chgData name="Connor Blair" userId="5dffaaf1-4e99-4a9f-9d58-f6e2d8990ba3" providerId="ADAL" clId="{8FA41CAE-FB9F-41C0-B3FF-4F4F7BC35C32}" dt="2024-03-12T11:58:25.002" v="2"/>
          <ac:graphicFrameMkLst>
            <pc:docMk/>
            <pc:sldMk cId="1278895754" sldId="289"/>
            <ac:graphicFrameMk id="3" creationId="{BDB01CD5-F30C-CF7D-78A2-DBF4CCF1C9F4}"/>
          </ac:graphicFrameMkLst>
        </pc:graphicFrameChg>
        <pc:graphicFrameChg chg="modGraphic">
          <ac:chgData name="Connor Blair" userId="5dffaaf1-4e99-4a9f-9d58-f6e2d8990ba3" providerId="ADAL" clId="{8FA41CAE-FB9F-41C0-B3FF-4F4F7BC35C32}" dt="2024-03-12T13:05:29.376" v="152" actId="20577"/>
          <ac:graphicFrameMkLst>
            <pc:docMk/>
            <pc:sldMk cId="1278895754" sldId="289"/>
            <ac:graphicFrameMk id="5" creationId="{9F82A9A4-3EB8-97F0-78B5-907E129E591F}"/>
          </ac:graphicFrameMkLst>
        </pc:graphicFrameChg>
      </pc:sldChg>
      <pc:sldChg chg="addSp delSp modSp add mod ord modNotesTx">
        <pc:chgData name="Connor Blair" userId="5dffaaf1-4e99-4a9f-9d58-f6e2d8990ba3" providerId="ADAL" clId="{8FA41CAE-FB9F-41C0-B3FF-4F4F7BC35C32}" dt="2024-03-14T17:49:49.658" v="719" actId="114"/>
        <pc:sldMkLst>
          <pc:docMk/>
          <pc:sldMk cId="2705641344" sldId="290"/>
        </pc:sldMkLst>
        <pc:spChg chg="mod">
          <ac:chgData name="Connor Blair" userId="5dffaaf1-4e99-4a9f-9d58-f6e2d8990ba3" providerId="ADAL" clId="{8FA41CAE-FB9F-41C0-B3FF-4F4F7BC35C32}" dt="2024-03-14T17:49:26.120" v="661" actId="20577"/>
          <ac:spMkLst>
            <pc:docMk/>
            <pc:sldMk cId="2705641344" sldId="290"/>
            <ac:spMk id="4" creationId="{EF41DF83-CFF1-209E-DF27-D250131B4B2D}"/>
          </ac:spMkLst>
        </pc:spChg>
        <pc:spChg chg="add mod">
          <ac:chgData name="Connor Blair" userId="5dffaaf1-4e99-4a9f-9d58-f6e2d8990ba3" providerId="ADAL" clId="{8FA41CAE-FB9F-41C0-B3FF-4F4F7BC35C32}" dt="2024-03-12T16:39:36.825" v="613" actId="1036"/>
          <ac:spMkLst>
            <pc:docMk/>
            <pc:sldMk cId="2705641344" sldId="290"/>
            <ac:spMk id="7" creationId="{D71AA253-E482-F539-D834-977F49D0D3A9}"/>
          </ac:spMkLst>
        </pc:spChg>
        <pc:spChg chg="add mod">
          <ac:chgData name="Connor Blair" userId="5dffaaf1-4e99-4a9f-9d58-f6e2d8990ba3" providerId="ADAL" clId="{8FA41CAE-FB9F-41C0-B3FF-4F4F7BC35C32}" dt="2024-03-12T16:39:36.825" v="613" actId="1036"/>
          <ac:spMkLst>
            <pc:docMk/>
            <pc:sldMk cId="2705641344" sldId="290"/>
            <ac:spMk id="8" creationId="{5C7462BD-B920-5C86-7949-9F1AC773D619}"/>
          </ac:spMkLst>
        </pc:spChg>
        <pc:spChg chg="add mod">
          <ac:chgData name="Connor Blair" userId="5dffaaf1-4e99-4a9f-9d58-f6e2d8990ba3" providerId="ADAL" clId="{8FA41CAE-FB9F-41C0-B3FF-4F4F7BC35C32}" dt="2024-03-12T16:39:36.825" v="613" actId="1036"/>
          <ac:spMkLst>
            <pc:docMk/>
            <pc:sldMk cId="2705641344" sldId="290"/>
            <ac:spMk id="9" creationId="{40F59AB3-013B-03EA-A660-F97B6E90727C}"/>
          </ac:spMkLst>
        </pc:spChg>
        <pc:spChg chg="add mod">
          <ac:chgData name="Connor Blair" userId="5dffaaf1-4e99-4a9f-9d58-f6e2d8990ba3" providerId="ADAL" clId="{8FA41CAE-FB9F-41C0-B3FF-4F4F7BC35C32}" dt="2024-03-12T16:39:48.903" v="615" actId="1076"/>
          <ac:spMkLst>
            <pc:docMk/>
            <pc:sldMk cId="2705641344" sldId="290"/>
            <ac:spMk id="14" creationId="{CB53E6DB-9F6C-DE54-A1C2-6132266CBE21}"/>
          </ac:spMkLst>
        </pc:spChg>
        <pc:spChg chg="add mod">
          <ac:chgData name="Connor Blair" userId="5dffaaf1-4e99-4a9f-9d58-f6e2d8990ba3" providerId="ADAL" clId="{8FA41CAE-FB9F-41C0-B3FF-4F4F7BC35C32}" dt="2024-03-12T16:39:52.677" v="618" actId="20577"/>
          <ac:spMkLst>
            <pc:docMk/>
            <pc:sldMk cId="2705641344" sldId="290"/>
            <ac:spMk id="15" creationId="{C6BA4A28-5268-06B2-666C-622EA48CED63}"/>
          </ac:spMkLst>
        </pc:spChg>
        <pc:spChg chg="add mod">
          <ac:chgData name="Connor Blair" userId="5dffaaf1-4e99-4a9f-9d58-f6e2d8990ba3" providerId="ADAL" clId="{8FA41CAE-FB9F-41C0-B3FF-4F4F7BC35C32}" dt="2024-03-12T16:40:00.545" v="621" actId="20577"/>
          <ac:spMkLst>
            <pc:docMk/>
            <pc:sldMk cId="2705641344" sldId="290"/>
            <ac:spMk id="16" creationId="{7D6210F5-DF68-3185-FA9B-292641BCA3C9}"/>
          </ac:spMkLst>
        </pc:spChg>
        <pc:spChg chg="add mod">
          <ac:chgData name="Connor Blair" userId="5dffaaf1-4e99-4a9f-9d58-f6e2d8990ba3" providerId="ADAL" clId="{8FA41CAE-FB9F-41C0-B3FF-4F4F7BC35C32}" dt="2024-03-12T16:40:10.343" v="636" actId="1036"/>
          <ac:spMkLst>
            <pc:docMk/>
            <pc:sldMk cId="2705641344" sldId="290"/>
            <ac:spMk id="17" creationId="{5F951902-992F-1600-8459-809019F9D36D}"/>
          </ac:spMkLst>
        </pc:spChg>
        <pc:graphicFrameChg chg="add del mod">
          <ac:chgData name="Connor Blair" userId="5dffaaf1-4e99-4a9f-9d58-f6e2d8990ba3" providerId="ADAL" clId="{8FA41CAE-FB9F-41C0-B3FF-4F4F7BC35C32}" dt="2024-03-12T13:00:01.508" v="9" actId="478"/>
          <ac:graphicFrameMkLst>
            <pc:docMk/>
            <pc:sldMk cId="2705641344" sldId="290"/>
            <ac:graphicFrameMk id="2" creationId="{2545CE18-9BD2-0B61-0113-2284B7481501}"/>
          </ac:graphicFrameMkLst>
        </pc:graphicFrameChg>
        <pc:graphicFrameChg chg="del">
          <ac:chgData name="Connor Blair" userId="5dffaaf1-4e99-4a9f-9d58-f6e2d8990ba3" providerId="ADAL" clId="{8FA41CAE-FB9F-41C0-B3FF-4F4F7BC35C32}" dt="2024-03-12T13:09:40.280" v="186" actId="478"/>
          <ac:graphicFrameMkLst>
            <pc:docMk/>
            <pc:sldMk cId="2705641344" sldId="290"/>
            <ac:graphicFrameMk id="3" creationId="{BDB01CD5-F30C-CF7D-78A2-DBF4CCF1C9F4}"/>
          </ac:graphicFrameMkLst>
        </pc:graphicFrameChg>
        <pc:graphicFrameChg chg="add del mod modGraphic">
          <ac:chgData name="Connor Blair" userId="5dffaaf1-4e99-4a9f-9d58-f6e2d8990ba3" providerId="ADAL" clId="{8FA41CAE-FB9F-41C0-B3FF-4F4F7BC35C32}" dt="2024-03-12T16:37:32.583" v="290" actId="1038"/>
          <ac:graphicFrameMkLst>
            <pc:docMk/>
            <pc:sldMk cId="2705641344" sldId="290"/>
            <ac:graphicFrameMk id="5" creationId="{9F82A9A4-3EB8-97F0-78B5-907E129E591F}"/>
          </ac:graphicFrameMkLst>
        </pc:graphicFrameChg>
        <pc:graphicFrameChg chg="add del mod">
          <ac:chgData name="Connor Blair" userId="5dffaaf1-4e99-4a9f-9d58-f6e2d8990ba3" providerId="ADAL" clId="{8FA41CAE-FB9F-41C0-B3FF-4F4F7BC35C32}" dt="2024-03-12T13:04:31.680" v="121" actId="478"/>
          <ac:graphicFrameMkLst>
            <pc:docMk/>
            <pc:sldMk cId="2705641344" sldId="290"/>
            <ac:graphicFrameMk id="6" creationId="{E8AB7017-EF43-A9B8-F9FF-6C10E5269053}"/>
          </ac:graphicFrameMkLst>
        </pc:graphicFrameChg>
        <pc:graphicFrameChg chg="add del mod">
          <ac:chgData name="Connor Blair" userId="5dffaaf1-4e99-4a9f-9d58-f6e2d8990ba3" providerId="ADAL" clId="{8FA41CAE-FB9F-41C0-B3FF-4F4F7BC35C32}" dt="2024-03-12T13:26:36.305" v="269" actId="478"/>
          <ac:graphicFrameMkLst>
            <pc:docMk/>
            <pc:sldMk cId="2705641344" sldId="290"/>
            <ac:graphicFrameMk id="10" creationId="{2462CF83-8A0E-5A72-0E60-A7C55A45AB6B}"/>
          </ac:graphicFrameMkLst>
        </pc:graphicFrameChg>
        <pc:graphicFrameChg chg="add mod">
          <ac:chgData name="Connor Blair" userId="5dffaaf1-4e99-4a9f-9d58-f6e2d8990ba3" providerId="ADAL" clId="{8FA41CAE-FB9F-41C0-B3FF-4F4F7BC35C32}" dt="2024-03-12T16:37:26.623" v="278" actId="1076"/>
          <ac:graphicFrameMkLst>
            <pc:docMk/>
            <pc:sldMk cId="2705641344" sldId="290"/>
            <ac:graphicFrameMk id="11" creationId="{3E7B8AF6-FC3E-4A01-609C-231EBDF51EF6}"/>
          </ac:graphicFrameMkLst>
        </pc:graphicFrameChg>
        <pc:graphicFrameChg chg="add mod">
          <ac:chgData name="Connor Blair" userId="5dffaaf1-4e99-4a9f-9d58-f6e2d8990ba3" providerId="ADAL" clId="{8FA41CAE-FB9F-41C0-B3FF-4F4F7BC35C32}" dt="2024-03-12T16:37:07.385" v="275" actId="1076"/>
          <ac:graphicFrameMkLst>
            <pc:docMk/>
            <pc:sldMk cId="2705641344" sldId="290"/>
            <ac:graphicFrameMk id="12" creationId="{FA08684C-FC91-EA00-5299-281D749E7BCF}"/>
          </ac:graphicFrameMkLst>
        </pc:graphicFrameChg>
        <pc:graphicFrameChg chg="add mod">
          <ac:chgData name="Connor Blair" userId="5dffaaf1-4e99-4a9f-9d58-f6e2d8990ba3" providerId="ADAL" clId="{8FA41CAE-FB9F-41C0-B3FF-4F4F7BC35C32}" dt="2024-03-12T16:37:21.594" v="277" actId="1076"/>
          <ac:graphicFrameMkLst>
            <pc:docMk/>
            <pc:sldMk cId="2705641344" sldId="290"/>
            <ac:graphicFrameMk id="13" creationId="{E34A632A-EC7C-E862-7D39-0BA587A63698}"/>
          </ac:graphicFrameMkLst>
        </pc:graphicFrameChg>
      </pc:sldChg>
    </pc:docChg>
  </pc:docChgLst>
  <pc:docChgLst>
    <pc:chgData name="Connor Blair" userId="5dffaaf1-4e99-4a9f-9d58-f6e2d8990ba3" providerId="ADAL" clId="{9D511298-BBB3-4F9E-98D6-0C0C94E12025}"/>
    <pc:docChg chg="undo custSel addSld delSld modSld sldOrd">
      <pc:chgData name="Connor Blair" userId="5dffaaf1-4e99-4a9f-9d58-f6e2d8990ba3" providerId="ADAL" clId="{9D511298-BBB3-4F9E-98D6-0C0C94E12025}" dt="2023-12-20T13:27:12.855" v="1282"/>
      <pc:docMkLst>
        <pc:docMk/>
      </pc:docMkLst>
      <pc:sldChg chg="delSp modSp mod modNotesTx">
        <pc:chgData name="Connor Blair" userId="5dffaaf1-4e99-4a9f-9d58-f6e2d8990ba3" providerId="ADAL" clId="{9D511298-BBB3-4F9E-98D6-0C0C94E12025}" dt="2023-12-20T13:26:59.991" v="1262"/>
        <pc:sldMkLst>
          <pc:docMk/>
          <pc:sldMk cId="2190305047" sldId="263"/>
        </pc:sldMkLst>
        <pc:spChg chg="del mod">
          <ac:chgData name="Connor Blair" userId="5dffaaf1-4e99-4a9f-9d58-f6e2d8990ba3" providerId="ADAL" clId="{9D511298-BBB3-4F9E-98D6-0C0C94E12025}" dt="2023-12-20T13:26:59.991" v="1262"/>
          <ac:spMkLst>
            <pc:docMk/>
            <pc:sldMk cId="2190305047" sldId="263"/>
            <ac:spMk id="2" creationId="{9D005E89-610B-8C40-7CF4-28D10B026F97}"/>
          </ac:spMkLst>
        </pc:spChg>
      </pc:sldChg>
      <pc:sldChg chg="modSp mod ord modNotesTx">
        <pc:chgData name="Connor Blair" userId="5dffaaf1-4e99-4a9f-9d58-f6e2d8990ba3" providerId="ADAL" clId="{9D511298-BBB3-4F9E-98D6-0C0C94E12025}" dt="2023-12-20T13:27:07.551" v="1274"/>
        <pc:sldMkLst>
          <pc:docMk/>
          <pc:sldMk cId="1032784987" sldId="276"/>
        </pc:sldMkLst>
        <pc:spChg chg="mod">
          <ac:chgData name="Connor Blair" userId="5dffaaf1-4e99-4a9f-9d58-f6e2d8990ba3" providerId="ADAL" clId="{9D511298-BBB3-4F9E-98D6-0C0C94E12025}" dt="2023-12-19T12:50:22.480" v="311" actId="20577"/>
          <ac:spMkLst>
            <pc:docMk/>
            <pc:sldMk cId="1032784987" sldId="276"/>
            <ac:spMk id="4" creationId="{6F746B87-F990-2B84-1C12-930D1D726CC1}"/>
          </ac:spMkLst>
        </pc:spChg>
        <pc:spChg chg="mod">
          <ac:chgData name="Connor Blair" userId="5dffaaf1-4e99-4a9f-9d58-f6e2d8990ba3" providerId="ADAL" clId="{9D511298-BBB3-4F9E-98D6-0C0C94E12025}" dt="2023-12-20T13:27:07.059" v="1273"/>
          <ac:spMkLst>
            <pc:docMk/>
            <pc:sldMk cId="1032784987" sldId="276"/>
            <ac:spMk id="10" creationId="{63F80C7E-1121-338E-055E-B4D6B5BD0E5E}"/>
          </ac:spMkLst>
        </pc:spChg>
      </pc:sldChg>
      <pc:sldChg chg="delSp del mod">
        <pc:chgData name="Connor Blair" userId="5dffaaf1-4e99-4a9f-9d58-f6e2d8990ba3" providerId="ADAL" clId="{9D511298-BBB3-4F9E-98D6-0C0C94E12025}" dt="2023-12-12T18:54:22.253" v="10" actId="47"/>
        <pc:sldMkLst>
          <pc:docMk/>
          <pc:sldMk cId="2020570190" sldId="277"/>
        </pc:sldMkLst>
        <pc:graphicFrameChg chg="del">
          <ac:chgData name="Connor Blair" userId="5dffaaf1-4e99-4a9f-9d58-f6e2d8990ba3" providerId="ADAL" clId="{9D511298-BBB3-4F9E-98D6-0C0C94E12025}" dt="2023-12-12T18:35:14.064" v="0" actId="478"/>
          <ac:graphicFrameMkLst>
            <pc:docMk/>
            <pc:sldMk cId="2020570190" sldId="277"/>
            <ac:graphicFrameMk id="12" creationId="{77E6CE52-D84E-92A1-B899-6932868707BC}"/>
          </ac:graphicFrameMkLst>
        </pc:graphicFrameChg>
        <pc:graphicFrameChg chg="del">
          <ac:chgData name="Connor Blair" userId="5dffaaf1-4e99-4a9f-9d58-f6e2d8990ba3" providerId="ADAL" clId="{9D511298-BBB3-4F9E-98D6-0C0C94E12025}" dt="2023-12-12T18:35:14.064" v="0" actId="478"/>
          <ac:graphicFrameMkLst>
            <pc:docMk/>
            <pc:sldMk cId="2020570190" sldId="277"/>
            <ac:graphicFrameMk id="18" creationId="{FC7806C2-4242-07D4-3F57-96E516FAC6CF}"/>
          </ac:graphicFrameMkLst>
        </pc:graphicFrameChg>
      </pc:sldChg>
      <pc:sldChg chg="delSp modSp mod modNotesTx">
        <pc:chgData name="Connor Blair" userId="5dffaaf1-4e99-4a9f-9d58-f6e2d8990ba3" providerId="ADAL" clId="{9D511298-BBB3-4F9E-98D6-0C0C94E12025}" dt="2023-12-20T13:27:02.263" v="1266"/>
        <pc:sldMkLst>
          <pc:docMk/>
          <pc:sldMk cId="2854840488" sldId="281"/>
        </pc:sldMkLst>
        <pc:spChg chg="del mod">
          <ac:chgData name="Connor Blair" userId="5dffaaf1-4e99-4a9f-9d58-f6e2d8990ba3" providerId="ADAL" clId="{9D511298-BBB3-4F9E-98D6-0C0C94E12025}" dt="2023-12-20T13:27:02.263" v="1266"/>
          <ac:spMkLst>
            <pc:docMk/>
            <pc:sldMk cId="2854840488" sldId="281"/>
            <ac:spMk id="2" creationId="{9D005E89-610B-8C40-7CF4-28D10B026F97}"/>
          </ac:spMkLst>
        </pc:spChg>
      </pc:sldChg>
      <pc:sldChg chg="delSp modSp mod modNotesTx">
        <pc:chgData name="Connor Blair" userId="5dffaaf1-4e99-4a9f-9d58-f6e2d8990ba3" providerId="ADAL" clId="{9D511298-BBB3-4F9E-98D6-0C0C94E12025}" dt="2023-12-20T13:27:04.717" v="1270"/>
        <pc:sldMkLst>
          <pc:docMk/>
          <pc:sldMk cId="2622173774" sldId="282"/>
        </pc:sldMkLst>
        <pc:spChg chg="del mod">
          <ac:chgData name="Connor Blair" userId="5dffaaf1-4e99-4a9f-9d58-f6e2d8990ba3" providerId="ADAL" clId="{9D511298-BBB3-4F9E-98D6-0C0C94E12025}" dt="2023-12-20T13:27:04.717" v="1270"/>
          <ac:spMkLst>
            <pc:docMk/>
            <pc:sldMk cId="2622173774" sldId="282"/>
            <ac:spMk id="19" creationId="{DCDC220A-1F3E-6C60-66DA-A9AC4DBCD14E}"/>
          </ac:spMkLst>
        </pc:spChg>
      </pc:sldChg>
      <pc:sldChg chg="addSp delSp modSp mod ord modNotesTx">
        <pc:chgData name="Connor Blair" userId="5dffaaf1-4e99-4a9f-9d58-f6e2d8990ba3" providerId="ADAL" clId="{9D511298-BBB3-4F9E-98D6-0C0C94E12025}" dt="2023-12-20T13:27:10.660" v="1278"/>
        <pc:sldMkLst>
          <pc:docMk/>
          <pc:sldMk cId="347423076" sldId="283"/>
        </pc:sldMkLst>
        <pc:spChg chg="mod">
          <ac:chgData name="Connor Blair" userId="5dffaaf1-4e99-4a9f-9d58-f6e2d8990ba3" providerId="ADAL" clId="{9D511298-BBB3-4F9E-98D6-0C0C94E12025}" dt="2023-12-19T12:50:25.095" v="313" actId="20577"/>
          <ac:spMkLst>
            <pc:docMk/>
            <pc:sldMk cId="347423076" sldId="283"/>
            <ac:spMk id="4" creationId="{6F746B87-F990-2B84-1C12-930D1D726CC1}"/>
          </ac:spMkLst>
        </pc:spChg>
        <pc:spChg chg="del mod">
          <ac:chgData name="Connor Blair" userId="5dffaaf1-4e99-4a9f-9d58-f6e2d8990ba3" providerId="ADAL" clId="{9D511298-BBB3-4F9E-98D6-0C0C94E12025}" dt="2023-12-20T13:27:10.660" v="1278"/>
          <ac:spMkLst>
            <pc:docMk/>
            <pc:sldMk cId="347423076" sldId="283"/>
            <ac:spMk id="10" creationId="{63F80C7E-1121-338E-055E-B4D6B5BD0E5E}"/>
          </ac:spMkLst>
        </pc:spChg>
        <pc:spChg chg="mod">
          <ac:chgData name="Connor Blair" userId="5dffaaf1-4e99-4a9f-9d58-f6e2d8990ba3" providerId="ADAL" clId="{9D511298-BBB3-4F9E-98D6-0C0C94E12025}" dt="2023-12-19T12:25:24.221" v="71" actId="1076"/>
          <ac:spMkLst>
            <pc:docMk/>
            <pc:sldMk cId="347423076" sldId="283"/>
            <ac:spMk id="19" creationId="{F4D06F58-1BA5-6F25-219D-87303183C7AD}"/>
          </ac:spMkLst>
        </pc:spChg>
        <pc:spChg chg="mod">
          <ac:chgData name="Connor Blair" userId="5dffaaf1-4e99-4a9f-9d58-f6e2d8990ba3" providerId="ADAL" clId="{9D511298-BBB3-4F9E-98D6-0C0C94E12025}" dt="2023-12-19T13:09:44.811" v="1015" actId="1035"/>
          <ac:spMkLst>
            <pc:docMk/>
            <pc:sldMk cId="347423076" sldId="283"/>
            <ac:spMk id="22" creationId="{DF6326AC-5C93-AB3C-98BD-AD3187DFFC33}"/>
          </ac:spMkLst>
        </pc:spChg>
        <pc:spChg chg="mod">
          <ac:chgData name="Connor Blair" userId="5dffaaf1-4e99-4a9f-9d58-f6e2d8990ba3" providerId="ADAL" clId="{9D511298-BBB3-4F9E-98D6-0C0C94E12025}" dt="2023-12-19T13:09:52.286" v="1046" actId="1035"/>
          <ac:spMkLst>
            <pc:docMk/>
            <pc:sldMk cId="347423076" sldId="283"/>
            <ac:spMk id="23" creationId="{914B80B1-0533-557C-1ADC-F293187018B8}"/>
          </ac:spMkLst>
        </pc:spChg>
        <pc:graphicFrameChg chg="add mod">
          <ac:chgData name="Connor Blair" userId="5dffaaf1-4e99-4a9f-9d58-f6e2d8990ba3" providerId="ADAL" clId="{9D511298-BBB3-4F9E-98D6-0C0C94E12025}" dt="2023-12-19T12:49:01.709" v="304"/>
          <ac:graphicFrameMkLst>
            <pc:docMk/>
            <pc:sldMk cId="347423076" sldId="283"/>
            <ac:graphicFrameMk id="2" creationId="{52BA6F23-724B-7457-82A6-C62E12352FB2}"/>
          </ac:graphicFrameMkLst>
        </pc:graphicFrameChg>
        <pc:graphicFrameChg chg="add mod">
          <ac:chgData name="Connor Blair" userId="5dffaaf1-4e99-4a9f-9d58-f6e2d8990ba3" providerId="ADAL" clId="{9D511298-BBB3-4F9E-98D6-0C0C94E12025}" dt="2023-12-19T13:09:44.811" v="1015" actId="1035"/>
          <ac:graphicFrameMkLst>
            <pc:docMk/>
            <pc:sldMk cId="347423076" sldId="283"/>
            <ac:graphicFrameMk id="3" creationId="{23D92948-31DA-9CA3-8E65-338B19F46AFD}"/>
          </ac:graphicFrameMkLst>
        </pc:graphicFrameChg>
        <pc:graphicFrameChg chg="del">
          <ac:chgData name="Connor Blair" userId="5dffaaf1-4e99-4a9f-9d58-f6e2d8990ba3" providerId="ADAL" clId="{9D511298-BBB3-4F9E-98D6-0C0C94E12025}" dt="2023-12-14T17:24:11.931" v="11" actId="478"/>
          <ac:graphicFrameMkLst>
            <pc:docMk/>
            <pc:sldMk cId="347423076" sldId="283"/>
            <ac:graphicFrameMk id="6" creationId="{F1A62843-AB76-0309-982F-83E678AB1C6D}"/>
          </ac:graphicFrameMkLst>
        </pc:graphicFrameChg>
        <pc:graphicFrameChg chg="del">
          <ac:chgData name="Connor Blair" userId="5dffaaf1-4e99-4a9f-9d58-f6e2d8990ba3" providerId="ADAL" clId="{9D511298-BBB3-4F9E-98D6-0C0C94E12025}" dt="2023-12-14T17:24:11.931" v="11" actId="478"/>
          <ac:graphicFrameMkLst>
            <pc:docMk/>
            <pc:sldMk cId="347423076" sldId="283"/>
            <ac:graphicFrameMk id="7" creationId="{0EF55170-24A0-6E72-AFC7-147863E5FCF9}"/>
          </ac:graphicFrameMkLst>
        </pc:graphicFrameChg>
        <pc:graphicFrameChg chg="mod modGraphic">
          <ac:chgData name="Connor Blair" userId="5dffaaf1-4e99-4a9f-9d58-f6e2d8990ba3" providerId="ADAL" clId="{9D511298-BBB3-4F9E-98D6-0C0C94E12025}" dt="2023-12-19T13:09:48.919" v="1034" actId="1036"/>
          <ac:graphicFrameMkLst>
            <pc:docMk/>
            <pc:sldMk cId="347423076" sldId="283"/>
            <ac:graphicFrameMk id="9" creationId="{1748EDC5-A994-AF67-5543-3F7A24CE7EAA}"/>
          </ac:graphicFrameMkLst>
        </pc:graphicFrameChg>
      </pc:sldChg>
      <pc:sldChg chg="delSp modSp mod modNotesTx">
        <pc:chgData name="Connor Blair" userId="5dffaaf1-4e99-4a9f-9d58-f6e2d8990ba3" providerId="ADAL" clId="{9D511298-BBB3-4F9E-98D6-0C0C94E12025}" dt="2023-12-20T13:26:57.011" v="1258"/>
        <pc:sldMkLst>
          <pc:docMk/>
          <pc:sldMk cId="1763265114" sldId="288"/>
        </pc:sldMkLst>
        <pc:spChg chg="del mod">
          <ac:chgData name="Connor Blair" userId="5dffaaf1-4e99-4a9f-9d58-f6e2d8990ba3" providerId="ADAL" clId="{9D511298-BBB3-4F9E-98D6-0C0C94E12025}" dt="2023-12-20T13:26:57.011" v="1258"/>
          <ac:spMkLst>
            <pc:docMk/>
            <pc:sldMk cId="1763265114" sldId="288"/>
            <ac:spMk id="2" creationId="{9D005E89-610B-8C40-7CF4-28D10B026F97}"/>
          </ac:spMkLst>
        </pc:spChg>
      </pc:sldChg>
      <pc:sldChg chg="addSp delSp modSp add mod modNotesTx">
        <pc:chgData name="Connor Blair" userId="5dffaaf1-4e99-4a9f-9d58-f6e2d8990ba3" providerId="ADAL" clId="{9D511298-BBB3-4F9E-98D6-0C0C94E12025}" dt="2023-12-20T13:27:12.855" v="1282"/>
        <pc:sldMkLst>
          <pc:docMk/>
          <pc:sldMk cId="1278895754" sldId="289"/>
        </pc:sldMkLst>
        <pc:spChg chg="del mod">
          <ac:chgData name="Connor Blair" userId="5dffaaf1-4e99-4a9f-9d58-f6e2d8990ba3" providerId="ADAL" clId="{9D511298-BBB3-4F9E-98D6-0C0C94E12025}" dt="2023-12-20T13:27:12.321" v="1281"/>
          <ac:spMkLst>
            <pc:docMk/>
            <pc:sldMk cId="1278895754" sldId="289"/>
            <ac:spMk id="2" creationId="{9D005E89-610B-8C40-7CF4-28D10B026F97}"/>
          </ac:spMkLst>
        </pc:spChg>
        <pc:spChg chg="mod">
          <ac:chgData name="Connor Blair" userId="5dffaaf1-4e99-4a9f-9d58-f6e2d8990ba3" providerId="ADAL" clId="{9D511298-BBB3-4F9E-98D6-0C0C94E12025}" dt="2023-12-15T16:00:17.305" v="19" actId="20577"/>
          <ac:spMkLst>
            <pc:docMk/>
            <pc:sldMk cId="1278895754" sldId="289"/>
            <ac:spMk id="4" creationId="{EF41DF83-CFF1-209E-DF27-D250131B4B2D}"/>
          </ac:spMkLst>
        </pc:spChg>
        <pc:graphicFrameChg chg="add mod">
          <ac:chgData name="Connor Blair" userId="5dffaaf1-4e99-4a9f-9d58-f6e2d8990ba3" providerId="ADAL" clId="{9D511298-BBB3-4F9E-98D6-0C0C94E12025}" dt="2023-12-19T12:52:04.653" v="338" actId="1076"/>
          <ac:graphicFrameMkLst>
            <pc:docMk/>
            <pc:sldMk cId="1278895754" sldId="289"/>
            <ac:graphicFrameMk id="3" creationId="{BDB01CD5-F30C-CF7D-78A2-DBF4CCF1C9F4}"/>
          </ac:graphicFrameMkLst>
        </pc:graphicFrameChg>
        <pc:graphicFrameChg chg="add mod modGraphic">
          <ac:chgData name="Connor Blair" userId="5dffaaf1-4e99-4a9f-9d58-f6e2d8990ba3" providerId="ADAL" clId="{9D511298-BBB3-4F9E-98D6-0C0C94E12025}" dt="2023-12-19T12:56:43.364" v="425" actId="1076"/>
          <ac:graphicFrameMkLst>
            <pc:docMk/>
            <pc:sldMk cId="1278895754" sldId="289"/>
            <ac:graphicFrameMk id="5" creationId="{9F82A9A4-3EB8-97F0-78B5-907E129E591F}"/>
          </ac:graphicFrameMkLst>
        </pc:graphicFrameChg>
        <pc:graphicFrameChg chg="del">
          <ac:chgData name="Connor Blair" userId="5dffaaf1-4e99-4a9f-9d58-f6e2d8990ba3" providerId="ADAL" clId="{9D511298-BBB3-4F9E-98D6-0C0C94E12025}" dt="2023-12-15T16:00:31.144" v="54" actId="478"/>
          <ac:graphicFrameMkLst>
            <pc:docMk/>
            <pc:sldMk cId="1278895754" sldId="289"/>
            <ac:graphicFrameMk id="5" creationId="{AFDB2C51-5A2D-16B7-3F7A-BA9D494F23FA}"/>
          </ac:graphicFrameMkLst>
        </pc:graphicFrameChg>
        <pc:graphicFrameChg chg="add del mod">
          <ac:chgData name="Connor Blair" userId="5dffaaf1-4e99-4a9f-9d58-f6e2d8990ba3" providerId="ADAL" clId="{9D511298-BBB3-4F9E-98D6-0C0C94E12025}" dt="2023-12-15T16:08:09.369" v="65" actId="478"/>
          <ac:graphicFrameMkLst>
            <pc:docMk/>
            <pc:sldMk cId="1278895754" sldId="289"/>
            <ac:graphicFrameMk id="6" creationId="{050A1356-D83E-1E00-74AA-B238B1F3EE29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E723AD-2E02-4C2F-9A1C-07616C41FFC0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E2DD3F-F90B-42FD-BF2D-F2FB96A7A6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0496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1. DRx-170F (N=4) and DRx-150F (N=4) do not bind GST protein. </a:t>
            </a:r>
            <a:r>
              <a:rPr kumimoji="0" lang="en-GB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EAN ± SEM, N=4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2DD3F-F90B-42FD-BF2D-F2FB96A7A6C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51153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2. c-RAF Binding Epitope Sequence Analysis. 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Full-length human c-RAF structure including inhibitory PKA phospho-serine residues (43, 233, 259, 621), PDE8A1 binding peptides (P8, P49, P113-117, P123), RBD (Ras-Binding Domain), CRD (Cysteine Rich Domain), and Kinase Domain.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Pairwise protein BLAST comparing amino acid sequence of human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/B-RAF, KSR1/KSR2, MEK1/2 and ERK1/2 with human 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-RAF amino acid sequence corresponding to PDE8A1 binding peptide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(i) 8 (aa31-50),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i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49 (aa241-260),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ii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113-117 (aa561-600),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v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123 (aa611-630). % sequence identity to c-RAF presented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 the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RIGHT of respective sequences.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Table highlighting the sequence identity of human c-RAF vs. Mouse, Rat and Dog. aa, amino acid. 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2DD3F-F90B-42FD-BF2D-F2FB96A7A6C6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51153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3. c-RAF – PDE8A PPI Confirmation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ative control immunofluorescent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(composite) images of PANC1 cells (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sponding to 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2A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, demonstrating no background signal in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) primary antibodies only or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secondary antibodies only controls.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Nuclei counterstained with DAPI (blue) and composite highlighting areas of c-RAF – PDE8A colocalisation (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cale bar = 20 µm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.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Proximity ligation assay (PLA, red signal) validating c-RAF – PDE8A complex formation in fixed PANC1 cell cytoplasm and nuclei (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, with primary only (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and PLA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be only (middle) negative controls 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scale bar = 20 µm).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 of PANC1 cells treated with Vehicle (LEFT, 1% DMSO) or Sorafenib (RIGHT, 1 µM). # cells ≥ 75 per group.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Representative dot plot (N=3)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EAN ± SEM; ns, not significant. 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2DD3F-F90B-42FD-BF2D-F2FB96A7A6C6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511530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4. In Vitro 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x-170 Stability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RTCA (xCELLigence) of PANC1 cells following 60 Hrs treatment with Vehicle [1% DMSO] or DRx-170 [0.3 µM] in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2% FBS and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i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10% FBS conditions,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ii</a:t>
            </a:r>
            <a:r>
              <a:rPr kumimoji="0" lang="en-GB" sz="1200" b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respective bar chart highlighting the rate of cell growth (% slope of normalised cell index (nCI)) between 0-24 Hrs, 24-48 Hrs and 48-60 Hrs time points (N=3). ns, not significant; ****, P &lt; 0.0001 vs. Vehicle; #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P &lt; 0.05 vs. different time points.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In vitro (ADME) investigation of DRx-170 stability in rat plasma (2 Hrs duration) and liver microsomes (1 Hr duration), with estimated half-life (T ½, minutes) and CLint (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L/min/mg protein)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sured.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RTCA (xCELLigence) of PANC1 cells following 60 Hrs treatment with Vehicle [1% DMSO] or [0.45 µM] DRx-170 (counterions; TFA, HCl, Acetate) and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respective slope of nCI.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Initial 8 Hr of treatment period cropped to assess time point which DRx-170 activity begins,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respective slope of nCI (n=6)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EAN ± SEM,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, not significant; ***, P &lt; 0.001; ****, P &lt; 0.0001.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2DD3F-F90B-42FD-BF2D-F2FB96A7A6C6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56756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5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RAS-RAF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DE8A Mutational Status vs. c-RAF-PDE8A Genetic Dependency. </a:t>
            </a:r>
            <a:r>
              <a:rPr kumimoji="0" lang="en-GB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r>
              <a:rPr kumimoji="0" lang="en-GB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c-RAF and (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r>
              <a:rPr kumimoji="0" lang="en-GB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PDE8A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0" lang="en-GB" sz="12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ne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GB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ependency levels (CERES Score, CRISPR-Cas9 essentiality screen) derived from DepMap datasets in human cancer cell lines that are RAS wild-</a:t>
            </a:r>
            <a:r>
              <a:rPr kumimoji="0" lang="en-GB" sz="12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yp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 (n=833) vs. RAS mutant (n=246). c-RAF genetic dependency in human cancer cell lines expressing: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KRAS wild-type vs. KRAS mutations,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NRAS wild-type vs. NRAS mutations,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HRAS wild-type vs. HRAS mutations.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A/B/c-RAF wild-type vs. A/B/C-RAF mutations.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c-RAF gene dependency in human cancer cell lines expressing PDE8A wild-type vs. PDE8A mutations. (H) 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-RAF gene dependency in non-small-cell lung cancer (NSCLC)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=92), colorectal adenocarcinoma (COAD)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=57), pancreatic adenocarcinoma (PAAD)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=45), and other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=877) human cancer cell lines. % KRAS mutational prevalence below.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, not significant; **, P &lt; 0.01; ***, P &lt; 0.001; ****, P &lt; 0.0001. Unless otherwise stated, all mutant conditions (combined or specific mutant sub-groups) were compared statistically to their respective wild-type sub-group. Where the total number of cell lines with a specific RAS mutation was less than 5, data was not included. </a:t>
            </a:r>
            <a:r>
              <a:rPr lang="en-GB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e Supplementary Data Set 2.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2DD3F-F90B-42FD-BF2D-F2FB96A7A6C6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38968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6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C1 and Panc08.13 Cell Line Profile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lative Gene Effect levels (RNAi, </a:t>
            </a:r>
            <a:r>
              <a:rPr lang="en-GB" sz="12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hilles + DRIVE + Marcotte, DEMETER2) 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f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KRAS and (</a:t>
            </a:r>
            <a:r>
              <a:rPr kumimoji="0" lang="en-GB" sz="12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AF </a:t>
            </a:r>
            <a:r>
              <a:rPr kumimoji="0" lang="en-GB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 human cancer cell lines derived from DepMap (n=666).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rizontal lines represent median (Q2, 50</a:t>
            </a:r>
            <a:r>
              <a:rPr lang="en-GB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ercentile) and 25</a:t>
            </a:r>
            <a:r>
              <a:rPr lang="en-GB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Q1) / 75</a:t>
            </a:r>
            <a:r>
              <a:rPr lang="en-GB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Q3) percentiles. Gene dependency is Q1 &gt; Q2 &gt; Q3 (i.e., lower gene effect = higher gene dependency). Mean PAAD (pancreatic ductal adenocarcinoma) gene effect (n=28) highlighted by horizontal red line. (</a:t>
            </a:r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Summarised profiles of selected human PDAC PANC1 and Panc08.13 cell lines, including mutational status of hallmark PDAC genes (KRAS, TP53, SMAD4, CDKN2A) and c-RAF/KRAS gene dependency (RNAi). c-RAF/KRAS gene effect is ranked out of full 666 human cancer cell line database (i.e., 1 / 666 = most dependent). WT, wild-type; MT, mutant; -/-, homozygous deletion; fs, frameshift. </a:t>
            </a:r>
            <a:r>
              <a:rPr lang="en-GB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e Supplementary Data Set 3.</a:t>
            </a:r>
            <a:endParaRPr lang="en-GB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2DD3F-F90B-42FD-BF2D-F2FB96A7A6C6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58405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7.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n vitro DRx-170 sensitivity vs. other KRAS mutant human cancer cell lines. </a:t>
            </a:r>
            <a:r>
              <a:rPr kumimoji="0" lang="en-GB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TCA (xCELLigence) of (A) HCT116 colorectal cancer (KRAS G13D), (B) NCI-H460 non-small cell lung cancer (KRAS Q61H), (C) A549 non-small cell lung cancer (KRAS G12S) cell lines following 36 Hr treatment with vehicle [1% DMSO] or DRx-170 [0.1 µM]. (D) c-RAF/KRAS gene dependency (RNAi). c-RAF/KRAS gene effect is ranked out of full 666 human cancer cell line database (i.e., 1 / 666 = most dependent). </a:t>
            </a:r>
            <a:r>
              <a:rPr kumimoji="0" lang="en-GB" sz="120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GI, cell growth inhibition.</a:t>
            </a:r>
            <a:endParaRPr lang="en-GB" i="1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2DD3F-F90B-42FD-BF2D-F2FB96A7A6C6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061460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8.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n vitro DRx-170 sensitivity vs. RAS/RAF wild-type U2-OS human osteosarcoma (bone) cell line. </a:t>
            </a:r>
            <a:r>
              <a:rPr kumimoji="0" lang="en-GB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TOP) RTCA (xCELLigence) of U2-OS following 24 Hr treatment with vehicle [1% DMSO] or DRx-170 [0.1 µM]. (BOTTOM) c-RAF/KRAS gene dependency (RNAi). c-RAF/KRAS gene effect is ranked out of full 666 human cancer cell line database (i.e., 1 / 666 = most dependent) 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2DD3F-F90B-42FD-BF2D-F2FB96A7A6C6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0099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5610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5098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836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45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6280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141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2705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33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8471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01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5109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904DB-C9B3-40FA-8187-72FD223B53BD}" type="datetimeFigureOut">
              <a:rPr lang="en-GB" smtClean="0"/>
              <a:t>14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3705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13" Type="http://schemas.openxmlformats.org/officeDocument/2006/relationships/oleObject" Target="../embeddings/oleObject8.bin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14.em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5" Type="http://schemas.openxmlformats.org/officeDocument/2006/relationships/oleObject" Target="../embeddings/oleObject9.bin"/><Relationship Id="rId10" Type="http://schemas.openxmlformats.org/officeDocument/2006/relationships/image" Target="../media/image13.emf"/><Relationship Id="rId4" Type="http://schemas.openxmlformats.org/officeDocument/2006/relationships/image" Target="../media/image10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oleObject" Target="../embeddings/oleObject15.bin"/><Relationship Id="rId18" Type="http://schemas.openxmlformats.org/officeDocument/2006/relationships/image" Target="../media/image24.e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12" Type="http://schemas.openxmlformats.org/officeDocument/2006/relationships/image" Target="../media/image21.emf"/><Relationship Id="rId17" Type="http://schemas.openxmlformats.org/officeDocument/2006/relationships/oleObject" Target="../embeddings/oleObject17.bin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emf"/><Relationship Id="rId11" Type="http://schemas.openxmlformats.org/officeDocument/2006/relationships/oleObject" Target="../embeddings/oleObject14.bin"/><Relationship Id="rId5" Type="http://schemas.openxmlformats.org/officeDocument/2006/relationships/oleObject" Target="../embeddings/oleObject11.bin"/><Relationship Id="rId15" Type="http://schemas.openxmlformats.org/officeDocument/2006/relationships/oleObject" Target="../embeddings/oleObject16.bin"/><Relationship Id="rId10" Type="http://schemas.openxmlformats.org/officeDocument/2006/relationships/image" Target="../media/image20.emf"/><Relationship Id="rId4" Type="http://schemas.openxmlformats.org/officeDocument/2006/relationships/image" Target="../media/image17.emf"/><Relationship Id="rId9" Type="http://schemas.openxmlformats.org/officeDocument/2006/relationships/oleObject" Target="../embeddings/oleObject13.bin"/><Relationship Id="rId14" Type="http://schemas.openxmlformats.org/officeDocument/2006/relationships/image" Target="../media/image2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8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19.bin"/><Relationship Id="rId4" Type="http://schemas.openxmlformats.org/officeDocument/2006/relationships/image" Target="../media/image25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3" Type="http://schemas.openxmlformats.org/officeDocument/2006/relationships/oleObject" Target="../embeddings/oleObject20.bin"/><Relationship Id="rId7" Type="http://schemas.openxmlformats.org/officeDocument/2006/relationships/oleObject" Target="../embeddings/oleObject22.bin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emf"/><Relationship Id="rId5" Type="http://schemas.openxmlformats.org/officeDocument/2006/relationships/oleObject" Target="../embeddings/oleObject21.bin"/><Relationship Id="rId4" Type="http://schemas.openxmlformats.org/officeDocument/2006/relationships/image" Target="../media/image27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3.bin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41DF83-CFF1-209E-DF27-D250131B4B2D}"/>
              </a:ext>
            </a:extLst>
          </p:cNvPr>
          <p:cNvSpPr txBox="1"/>
          <p:nvPr/>
        </p:nvSpPr>
        <p:spPr>
          <a:xfrm>
            <a:off x="0" y="0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FDB2C51-5A2D-16B7-3F7A-BA9D494F23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0929509"/>
              </p:ext>
            </p:extLst>
          </p:nvPr>
        </p:nvGraphicFramePr>
        <p:xfrm>
          <a:off x="1437611" y="830263"/>
          <a:ext cx="3843338" cy="206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4105279" imgH="2227802" progId="Prism8.Document">
                  <p:embed/>
                </p:oleObj>
              </mc:Choice>
              <mc:Fallback>
                <p:oleObj name="Prism 8" r:id="rId3" imgW="4105279" imgH="2227802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AFDB2C51-5A2D-16B7-3F7A-BA9D494F23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37611" y="830263"/>
                        <a:ext cx="3843338" cy="206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63265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41DF83-CFF1-209E-DF27-D250131B4B2D}"/>
              </a:ext>
            </a:extLst>
          </p:cNvPr>
          <p:cNvSpPr txBox="1"/>
          <p:nvPr/>
        </p:nvSpPr>
        <p:spPr>
          <a:xfrm>
            <a:off x="0" y="0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CABE021-DFB0-5EEC-BDCA-31E99BD0420A}"/>
              </a:ext>
            </a:extLst>
          </p:cNvPr>
          <p:cNvSpPr txBox="1"/>
          <p:nvPr/>
        </p:nvSpPr>
        <p:spPr>
          <a:xfrm>
            <a:off x="312446" y="39921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5C8CD6C1-BF8B-1902-74C8-E259FB5917AE}"/>
              </a:ext>
            </a:extLst>
          </p:cNvPr>
          <p:cNvGrpSpPr/>
          <p:nvPr/>
        </p:nvGrpSpPr>
        <p:grpSpPr>
          <a:xfrm>
            <a:off x="604284" y="565449"/>
            <a:ext cx="5801831" cy="1313084"/>
            <a:chOff x="805460" y="191593"/>
            <a:chExt cx="5801831" cy="131308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F8B3DDEE-151D-297E-0EE7-27CE9275FE30}"/>
                </a:ext>
              </a:extLst>
            </p:cNvPr>
            <p:cNvGrpSpPr/>
            <p:nvPr/>
          </p:nvGrpSpPr>
          <p:grpSpPr>
            <a:xfrm>
              <a:off x="805460" y="191593"/>
              <a:ext cx="5801831" cy="1313084"/>
              <a:chOff x="-307275" y="-516392"/>
              <a:chExt cx="6966449" cy="2058172"/>
            </a:xfrm>
          </p:grpSpPr>
          <p:sp>
            <p:nvSpPr>
              <p:cNvPr id="10" name="Rectangle: Rounded Corners 9">
                <a:extLst>
                  <a:ext uri="{FF2B5EF4-FFF2-40B4-BE49-F238E27FC236}">
                    <a16:creationId xmlns:a16="http://schemas.microsoft.com/office/drawing/2014/main" id="{9519E3FC-AFB2-62C6-042D-1576BEA85EAE}"/>
                  </a:ext>
                </a:extLst>
              </p:cNvPr>
              <p:cNvSpPr/>
              <p:nvPr/>
            </p:nvSpPr>
            <p:spPr>
              <a:xfrm>
                <a:off x="120218" y="876479"/>
                <a:ext cx="5586656" cy="49682"/>
              </a:xfrm>
              <a:prstGeom prst="roundRect">
                <a:avLst/>
              </a:prstGeom>
              <a:solidFill>
                <a:srgbClr val="862A2A"/>
              </a:solidFill>
              <a:ln>
                <a:solidFill>
                  <a:srgbClr val="862A2A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ectangle: Rounded Corners 10">
                <a:extLst>
                  <a:ext uri="{FF2B5EF4-FFF2-40B4-BE49-F238E27FC236}">
                    <a16:creationId xmlns:a16="http://schemas.microsoft.com/office/drawing/2014/main" id="{E2C9E82B-989E-0934-1784-06C1D09FE952}"/>
                  </a:ext>
                </a:extLst>
              </p:cNvPr>
              <p:cNvSpPr/>
              <p:nvPr/>
            </p:nvSpPr>
            <p:spPr>
              <a:xfrm>
                <a:off x="581657" y="709694"/>
                <a:ext cx="651569" cy="383255"/>
              </a:xfrm>
              <a:prstGeom prst="roundRect">
                <a:avLst/>
              </a:prstGeom>
              <a:gradFill flip="none" rotWithShape="1">
                <a:gsLst>
                  <a:gs pos="0">
                    <a:srgbClr val="EBBFBF"/>
                  </a:gs>
                  <a:gs pos="50000">
                    <a:srgbClr val="D77F7F"/>
                  </a:gs>
                  <a:gs pos="100000">
                    <a:srgbClr val="C84D4C"/>
                  </a:gs>
                </a:gsLst>
                <a:lin ang="5400000" scaled="1"/>
                <a:tileRect/>
              </a:gradFill>
              <a:ln w="19050">
                <a:solidFill>
                  <a:srgbClr val="862A2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: Rounded Corners 11">
                <a:extLst>
                  <a:ext uri="{FF2B5EF4-FFF2-40B4-BE49-F238E27FC236}">
                    <a16:creationId xmlns:a16="http://schemas.microsoft.com/office/drawing/2014/main" id="{68346F25-F55A-83BB-181A-A51365746BB6}"/>
                  </a:ext>
                </a:extLst>
              </p:cNvPr>
              <p:cNvSpPr/>
              <p:nvPr/>
            </p:nvSpPr>
            <p:spPr>
              <a:xfrm>
                <a:off x="1302644" y="709694"/>
                <a:ext cx="384259" cy="383255"/>
              </a:xfrm>
              <a:prstGeom prst="roundRect">
                <a:avLst/>
              </a:prstGeom>
              <a:gradFill flip="none" rotWithShape="1">
                <a:gsLst>
                  <a:gs pos="0">
                    <a:srgbClr val="EBBFBF"/>
                  </a:gs>
                  <a:gs pos="50000">
                    <a:srgbClr val="D77F7F"/>
                  </a:gs>
                  <a:gs pos="100000">
                    <a:srgbClr val="C84D4C"/>
                  </a:gs>
                </a:gsLst>
                <a:lin ang="5400000" scaled="1"/>
                <a:tileRect/>
              </a:gradFill>
              <a:ln w="19050">
                <a:solidFill>
                  <a:srgbClr val="862A2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Flowchart: Connector 13">
                <a:extLst>
                  <a:ext uri="{FF2B5EF4-FFF2-40B4-BE49-F238E27FC236}">
                    <a16:creationId xmlns:a16="http://schemas.microsoft.com/office/drawing/2014/main" id="{A881CDCA-9DA5-51E8-3554-8C31A2C4AF15}"/>
                  </a:ext>
                </a:extLst>
              </p:cNvPr>
              <p:cNvSpPr/>
              <p:nvPr/>
            </p:nvSpPr>
            <p:spPr>
              <a:xfrm>
                <a:off x="3133273" y="709694"/>
                <a:ext cx="2227527" cy="383255"/>
              </a:xfrm>
              <a:prstGeom prst="flowChartConnector">
                <a:avLst/>
              </a:prstGeom>
              <a:gradFill flip="none" rotWithShape="1">
                <a:gsLst>
                  <a:gs pos="0">
                    <a:srgbClr val="EBBFBF"/>
                  </a:gs>
                  <a:gs pos="50000">
                    <a:srgbClr val="D77F7F"/>
                  </a:gs>
                  <a:gs pos="100000">
                    <a:srgbClr val="C84D4C"/>
                  </a:gs>
                </a:gsLst>
                <a:lin ang="5400000" scaled="1"/>
                <a:tileRect/>
              </a:gradFill>
              <a:ln w="19050">
                <a:solidFill>
                  <a:srgbClr val="862A2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9932858-758F-3CA6-C438-329EDB943A17}"/>
                  </a:ext>
                </a:extLst>
              </p:cNvPr>
              <p:cNvSpPr txBox="1"/>
              <p:nvPr/>
            </p:nvSpPr>
            <p:spPr>
              <a:xfrm>
                <a:off x="624230" y="324239"/>
                <a:ext cx="591292" cy="4100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BD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737DA79-C316-2646-EF24-D4BE1DFEFBEA}"/>
                  </a:ext>
                </a:extLst>
              </p:cNvPr>
              <p:cNvSpPr txBox="1"/>
              <p:nvPr/>
            </p:nvSpPr>
            <p:spPr>
              <a:xfrm>
                <a:off x="3556805" y="340159"/>
                <a:ext cx="1445894" cy="4100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inase Domain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70C6D31-87D6-1A2B-950B-B5CB64B5F191}"/>
                  </a:ext>
                </a:extLst>
              </p:cNvPr>
              <p:cNvSpPr txBox="1"/>
              <p:nvPr/>
            </p:nvSpPr>
            <p:spPr>
              <a:xfrm>
                <a:off x="-303232" y="688345"/>
                <a:ext cx="475805" cy="3859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1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A78EF855-E2ED-98F5-8D0B-DF1039EA3D51}"/>
                  </a:ext>
                </a:extLst>
              </p:cNvPr>
              <p:cNvSpPr txBox="1"/>
              <p:nvPr/>
            </p:nvSpPr>
            <p:spPr>
              <a:xfrm>
                <a:off x="5653202" y="682431"/>
                <a:ext cx="645186" cy="3859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648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B365766-8828-35A1-21BD-1AB953EAE170}"/>
                  </a:ext>
                </a:extLst>
              </p:cNvPr>
              <p:cNvSpPr txBox="1"/>
              <p:nvPr/>
            </p:nvSpPr>
            <p:spPr>
              <a:xfrm>
                <a:off x="-307275" y="-516392"/>
                <a:ext cx="854987" cy="482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F333F36-6769-7BF1-EE82-1ADE2C8BF9FE}"/>
                  </a:ext>
                </a:extLst>
              </p:cNvPr>
              <p:cNvSpPr txBox="1"/>
              <p:nvPr/>
            </p:nvSpPr>
            <p:spPr>
              <a:xfrm>
                <a:off x="-158666" y="1204086"/>
                <a:ext cx="1150661" cy="33769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8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[aa31-50] </a:t>
                </a:r>
                <a:endParaRPr lang="en-GB" sz="800" i="1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6084B3A4-EA9B-3F6C-B379-879CB5BB774B}"/>
                  </a:ext>
                </a:extLst>
              </p:cNvPr>
              <p:cNvSpPr txBox="1"/>
              <p:nvPr/>
            </p:nvSpPr>
            <p:spPr>
              <a:xfrm>
                <a:off x="1753339" y="1194588"/>
                <a:ext cx="1364574" cy="33769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49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[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a241-260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  <a:r>
                  <a:rPr lang="en-GB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GB" sz="800" i="1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B61B18E4-5AC2-1FE7-CFCA-654D0895A4F4}"/>
                  </a:ext>
                </a:extLst>
              </p:cNvPr>
              <p:cNvSpPr txBox="1"/>
              <p:nvPr/>
            </p:nvSpPr>
            <p:spPr>
              <a:xfrm>
                <a:off x="3838478" y="1140709"/>
                <a:ext cx="1816770" cy="33769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113-117</a:t>
                </a:r>
                <a:r>
                  <a:rPr lang="en-GB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[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a561-600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  <a:r>
                  <a:rPr lang="en-GB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GB" sz="800" i="1" dirty="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585A6833-065A-15CC-62E7-70E2F60683FC}"/>
                  </a:ext>
                </a:extLst>
              </p:cNvPr>
              <p:cNvSpPr txBox="1"/>
              <p:nvPr/>
            </p:nvSpPr>
            <p:spPr>
              <a:xfrm>
                <a:off x="5311664" y="1192459"/>
                <a:ext cx="1347510" cy="33769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123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[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a611-630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  <a:r>
                  <a:rPr lang="en-GB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GB" sz="800" i="1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0653805-30C2-E018-A3F6-1B34181DE741}"/>
                  </a:ext>
                </a:extLst>
              </p:cNvPr>
              <p:cNvSpPr txBox="1"/>
              <p:nvPr/>
            </p:nvSpPr>
            <p:spPr>
              <a:xfrm>
                <a:off x="1197272" y="325228"/>
                <a:ext cx="591292" cy="4100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RD</a:t>
                </a:r>
              </a:p>
            </p:txBody>
          </p:sp>
        </p:grp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D0D28432-AB34-50A2-5DBD-5769D020C521}"/>
                </a:ext>
              </a:extLst>
            </p:cNvPr>
            <p:cNvCxnSpPr/>
            <p:nvPr/>
          </p:nvCxnSpPr>
          <p:spPr>
            <a:xfrm>
              <a:off x="1343120" y="905238"/>
              <a:ext cx="0" cy="212969"/>
            </a:xfrm>
            <a:prstGeom prst="line">
              <a:avLst/>
            </a:prstGeom>
            <a:ln w="317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3B665339-CDF3-6F6F-239C-6AFF56F3AEA0}"/>
                </a:ext>
              </a:extLst>
            </p:cNvPr>
            <p:cNvCxnSpPr/>
            <p:nvPr/>
          </p:nvCxnSpPr>
          <p:spPr>
            <a:xfrm>
              <a:off x="2923791" y="903830"/>
              <a:ext cx="0" cy="212969"/>
            </a:xfrm>
            <a:prstGeom prst="line">
              <a:avLst/>
            </a:prstGeom>
            <a:ln w="317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79396F57-9BC1-41B6-9D08-D2FECDAC083D}"/>
                </a:ext>
              </a:extLst>
            </p:cNvPr>
            <p:cNvCxnSpPr/>
            <p:nvPr/>
          </p:nvCxnSpPr>
          <p:spPr>
            <a:xfrm>
              <a:off x="2722340" y="903830"/>
              <a:ext cx="0" cy="212969"/>
            </a:xfrm>
            <a:prstGeom prst="line">
              <a:avLst/>
            </a:prstGeom>
            <a:ln w="317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5B2DAF7F-9710-AE27-8E7E-6DE118AE6A60}"/>
                </a:ext>
              </a:extLst>
            </p:cNvPr>
            <p:cNvCxnSpPr/>
            <p:nvPr/>
          </p:nvCxnSpPr>
          <p:spPr>
            <a:xfrm>
              <a:off x="5665401" y="903830"/>
              <a:ext cx="0" cy="212969"/>
            </a:xfrm>
            <a:prstGeom prst="line">
              <a:avLst/>
            </a:prstGeom>
            <a:ln w="317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C46E291-6F73-8915-BA0D-084ED6AB9A87}"/>
                </a:ext>
              </a:extLst>
            </p:cNvPr>
            <p:cNvSpPr txBox="1"/>
            <p:nvPr/>
          </p:nvSpPr>
          <p:spPr>
            <a:xfrm rot="16200000">
              <a:off x="1102637" y="630049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Ser43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E9D476D-E80F-E709-3B07-2586D4769A01}"/>
                </a:ext>
              </a:extLst>
            </p:cNvPr>
            <p:cNvSpPr txBox="1"/>
            <p:nvPr/>
          </p:nvSpPr>
          <p:spPr>
            <a:xfrm rot="16200000">
              <a:off x="2458261" y="605432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Ser233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9932167-493C-AC5C-F005-8E907E27FCF1}"/>
                </a:ext>
              </a:extLst>
            </p:cNvPr>
            <p:cNvSpPr txBox="1"/>
            <p:nvPr/>
          </p:nvSpPr>
          <p:spPr>
            <a:xfrm rot="16200000">
              <a:off x="2659689" y="606215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Ser259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CF76BD4-024F-4278-7E8E-DF6FEDFB2105}"/>
                </a:ext>
              </a:extLst>
            </p:cNvPr>
            <p:cNvSpPr txBox="1"/>
            <p:nvPr/>
          </p:nvSpPr>
          <p:spPr>
            <a:xfrm rot="16200000">
              <a:off x="5397510" y="605432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Ser621</a:t>
              </a:r>
            </a:p>
          </p:txBody>
        </p:sp>
      </p:grpSp>
      <p:sp>
        <p:nvSpPr>
          <p:cNvPr id="62" name="Right Brace 61">
            <a:extLst>
              <a:ext uri="{FF2B5EF4-FFF2-40B4-BE49-F238E27FC236}">
                <a16:creationId xmlns:a16="http://schemas.microsoft.com/office/drawing/2014/main" id="{FD6BCED6-4075-800F-9745-F64F9EA11276}"/>
              </a:ext>
            </a:extLst>
          </p:cNvPr>
          <p:cNvSpPr/>
          <p:nvPr/>
        </p:nvSpPr>
        <p:spPr>
          <a:xfrm rot="5400000">
            <a:off x="5416277" y="1568454"/>
            <a:ext cx="72000" cy="141464"/>
          </a:xfrm>
          <a:prstGeom prst="rightBrac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" name="Right Brace 62">
            <a:extLst>
              <a:ext uri="{FF2B5EF4-FFF2-40B4-BE49-F238E27FC236}">
                <a16:creationId xmlns:a16="http://schemas.microsoft.com/office/drawing/2014/main" id="{A6B551D6-D066-305E-0D9E-EF8950DEB34B}"/>
              </a:ext>
            </a:extLst>
          </p:cNvPr>
          <p:cNvSpPr/>
          <p:nvPr/>
        </p:nvSpPr>
        <p:spPr>
          <a:xfrm rot="5400000">
            <a:off x="5090388" y="1487432"/>
            <a:ext cx="72000" cy="306000"/>
          </a:xfrm>
          <a:prstGeom prst="rightBrac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ight Brace 63">
            <a:extLst>
              <a:ext uri="{FF2B5EF4-FFF2-40B4-BE49-F238E27FC236}">
                <a16:creationId xmlns:a16="http://schemas.microsoft.com/office/drawing/2014/main" id="{47E93B96-64C0-6BD8-9613-ADB123E5ABC5}"/>
              </a:ext>
            </a:extLst>
          </p:cNvPr>
          <p:cNvSpPr/>
          <p:nvPr/>
        </p:nvSpPr>
        <p:spPr>
          <a:xfrm rot="5400000">
            <a:off x="2682622" y="1574513"/>
            <a:ext cx="72000" cy="141464"/>
          </a:xfrm>
          <a:prstGeom prst="rightBrac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ight Brace 64">
            <a:extLst>
              <a:ext uri="{FF2B5EF4-FFF2-40B4-BE49-F238E27FC236}">
                <a16:creationId xmlns:a16="http://schemas.microsoft.com/office/drawing/2014/main" id="{3781DCCB-D071-90A9-D143-F3756E9CA260}"/>
              </a:ext>
            </a:extLst>
          </p:cNvPr>
          <p:cNvSpPr/>
          <p:nvPr/>
        </p:nvSpPr>
        <p:spPr>
          <a:xfrm rot="5400000">
            <a:off x="1100036" y="1578578"/>
            <a:ext cx="72000" cy="141464"/>
          </a:xfrm>
          <a:prstGeom prst="rightBrac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Rectangle 1">
            <a:extLst>
              <a:ext uri="{FF2B5EF4-FFF2-40B4-BE49-F238E27FC236}">
                <a16:creationId xmlns:a16="http://schemas.microsoft.com/office/drawing/2014/main" id="{0FD96C30-20EC-EE8E-5B40-826243646E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689" y="2479109"/>
            <a:ext cx="2688236" cy="124649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b="1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RAF </a:t>
            </a:r>
            <a:r>
              <a:rPr lang="en-US" altLang="en-US" sz="9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YQ</a:t>
            </a:r>
            <a:r>
              <a:rPr lang="en-US" altLang="en-US" sz="900" b="1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R</a:t>
            </a:r>
            <a:r>
              <a:rPr lang="en-US" altLang="en-US" sz="9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D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b="1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en-US" sz="9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b="1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S</a:t>
            </a:r>
            <a:r>
              <a:rPr lang="en-US" altLang="en-US" sz="900" b="1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50 [100%]</a:t>
            </a:r>
            <a:r>
              <a:rPr lang="en-US" altLang="en-US" sz="900" b="1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-RAF 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N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N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154 [15%] </a:t>
            </a: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RAF 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P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PA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V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18 [10%] </a:t>
            </a:r>
            <a:r>
              <a:rPr lang="en-US" alt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SR1 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R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T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P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PP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K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 295 [5%]  </a:t>
            </a: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SR2 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KK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P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K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 297 [10%] </a:t>
            </a: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2K1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-----   0 [0%] 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2K2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-----   0 [0%] 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K3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-----   0 [0%] 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K1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-----   0 [0%] 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853F2FA-9782-B26F-B1E3-DAD1633C85D2}"/>
              </a:ext>
            </a:extLst>
          </p:cNvPr>
          <p:cNvSpPr txBox="1"/>
          <p:nvPr/>
        </p:nvSpPr>
        <p:spPr>
          <a:xfrm>
            <a:off x="608824" y="2171798"/>
            <a:ext cx="2372737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eaLnBrk="0" fontAlgn="base" hangingPunct="0">
              <a:spcBef>
                <a:spcPct val="30000"/>
              </a:spcBef>
              <a:spcAft>
                <a:spcPct val="0"/>
              </a:spcAft>
            </a:pPr>
            <a:r>
              <a:rPr lang="en-US" altLang="en-US" sz="1050" b="1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AF peptide 8:</a:t>
            </a:r>
            <a:r>
              <a:rPr lang="en-US" altLang="en-US" sz="1050" b="1" dirty="0">
                <a:solidFill>
                  <a:srgbClr val="8080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a31-50</a:t>
            </a:r>
            <a:endParaRPr lang="en-US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107ECFD-2FAD-5FA1-09C4-B4C7292B9CDC}"/>
              </a:ext>
            </a:extLst>
          </p:cNvPr>
          <p:cNvSpPr txBox="1"/>
          <p:nvPr/>
        </p:nvSpPr>
        <p:spPr>
          <a:xfrm>
            <a:off x="311440" y="2037884"/>
            <a:ext cx="5854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 (i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E0EA247-8D28-8B5B-036C-D28815058248}"/>
              </a:ext>
            </a:extLst>
          </p:cNvPr>
          <p:cNvSpPr txBox="1"/>
          <p:nvPr/>
        </p:nvSpPr>
        <p:spPr>
          <a:xfrm>
            <a:off x="3273555" y="2037884"/>
            <a:ext cx="6431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 (ii)</a:t>
            </a:r>
          </a:p>
        </p:txBody>
      </p:sp>
      <p:sp>
        <p:nvSpPr>
          <p:cNvPr id="70" name="Rectangle 1">
            <a:extLst>
              <a:ext uri="{FF2B5EF4-FFF2-40B4-BE49-F238E27FC236}">
                <a16:creationId xmlns:a16="http://schemas.microsoft.com/office/drawing/2014/main" id="{DEEB116B-3FC6-EA26-3622-C87326BB36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0348" y="2479109"/>
            <a:ext cx="2757166" cy="124649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b="1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RAF 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T</a:t>
            </a:r>
            <a:r>
              <a:rPr lang="en-US" altLang="en-US" sz="900" b="1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en-US" sz="9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en-US" sz="9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</a:t>
            </a:r>
            <a:r>
              <a:rPr lang="en-US" altLang="en-US" sz="9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TST</a:t>
            </a:r>
            <a:r>
              <a:rPr lang="en-US" altLang="en-US" sz="900" b="1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260 [100%]</a:t>
            </a:r>
            <a:endParaRPr lang="en-US" altLang="en-US" sz="900" b="1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-RAF 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ED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Q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366 [25%] </a:t>
            </a:r>
            <a:endParaRPr lang="en-US" altLang="en-US" sz="9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RAF 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APA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PL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TST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215 [40%] </a:t>
            </a:r>
            <a:endParaRPr lang="en-US" alt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SR1 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Q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488 [20%] </a:t>
            </a: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KSR2 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L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CT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Q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561 [10%] </a:t>
            </a:r>
            <a:endParaRPr lang="en-US" altLang="en-US" sz="9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2K1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   0 [0%]  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2K2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   0 [0%]  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K3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   0 [0%]  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K1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   0 [0%]  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D1D82E0-2136-50F3-A1D9-6609628725E3}"/>
              </a:ext>
            </a:extLst>
          </p:cNvPr>
          <p:cNvSpPr txBox="1"/>
          <p:nvPr/>
        </p:nvSpPr>
        <p:spPr>
          <a:xfrm>
            <a:off x="3760476" y="2171798"/>
            <a:ext cx="2372737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eaLnBrk="0" fontAlgn="base" hangingPunct="0">
              <a:spcBef>
                <a:spcPct val="30000"/>
              </a:spcBef>
              <a:spcAft>
                <a:spcPct val="0"/>
              </a:spcAft>
            </a:pPr>
            <a:r>
              <a:rPr lang="en-US" altLang="en-US" sz="1050" b="1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AF peptide 49:</a:t>
            </a:r>
            <a:r>
              <a:rPr lang="en-US" altLang="en-US" sz="1050" b="1" dirty="0">
                <a:solidFill>
                  <a:srgbClr val="8080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a241-260</a:t>
            </a:r>
            <a:endParaRPr lang="en-US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D2C3235-567F-5510-7C64-1F52DAAE5846}"/>
              </a:ext>
            </a:extLst>
          </p:cNvPr>
          <p:cNvSpPr txBox="1"/>
          <p:nvPr/>
        </p:nvSpPr>
        <p:spPr>
          <a:xfrm>
            <a:off x="311440" y="3932301"/>
            <a:ext cx="700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 (iii)</a:t>
            </a:r>
          </a:p>
        </p:txBody>
      </p:sp>
      <p:sp>
        <p:nvSpPr>
          <p:cNvPr id="73" name="Rectangle 13">
            <a:extLst>
              <a:ext uri="{FF2B5EF4-FFF2-40B4-BE49-F238E27FC236}">
                <a16:creationId xmlns:a16="http://schemas.microsoft.com/office/drawing/2014/main" id="{456F49E4-3964-7446-46A8-2C230E7B22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4845" y="4311176"/>
            <a:ext cx="4825039" cy="1758943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algn="r" eaLnBrk="0" fontAlgn="base" hangingPunct="0">
              <a:spcBef>
                <a:spcPct val="30000"/>
              </a:spcBef>
              <a:spcAft>
                <a:spcPct val="0"/>
              </a:spcAft>
            </a:pPr>
            <a:r>
              <a:rPr lang="en-US" altLang="en-US" sz="900" b="1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RAF 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Y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b="1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b="1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C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b="1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A</a:t>
            </a:r>
            <a:r>
              <a:rPr lang="en-US" altLang="en-US" sz="900" b="1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K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b="1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E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LFP</a:t>
            </a:r>
            <a:r>
              <a:rPr lang="en-US" altLang="en-US" sz="900" b="1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600 [100%] </a:t>
            </a:r>
            <a:endParaRPr lang="en-US" altLang="en-US" sz="900" b="1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3000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-RAF 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Y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NC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MA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KKR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E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LFP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708 [77.5%]</a:t>
            </a:r>
            <a:endParaRPr lang="en-US" altLang="en-US" sz="9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3000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RAF 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Y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NC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R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E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LFP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561 [72.5%]</a:t>
            </a:r>
          </a:p>
          <a:p>
            <a:pPr lvl="0" algn="r" eaLnBrk="0" fontAlgn="base" hangingPunct="0">
              <a:spcBef>
                <a:spcPct val="3000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SR1 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G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L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L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WAF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871 [17.5%]</a:t>
            </a:r>
            <a:endParaRPr lang="en-US" altLang="en-US" sz="9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3000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SR2 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T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Q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LLF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WAF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en-US" sz="900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E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922 [5%]   </a:t>
            </a:r>
            <a:endParaRPr lang="en-US" altLang="en-US" sz="9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2K1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PMAIF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Y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P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G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F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V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A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353 [17.5%]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2K2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AMAIF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Y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P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G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F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V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A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361 [20%]  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K3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Y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AWA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F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322 [15%]  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K1 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Y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PW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F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L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305 [12.5%]</a:t>
            </a:r>
            <a:endParaRPr lang="en-US" altLang="en-US" sz="9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                 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AB46777-BC7C-D54F-7390-9F1975503B2C}"/>
              </a:ext>
            </a:extLst>
          </p:cNvPr>
          <p:cNvSpPr txBox="1"/>
          <p:nvPr/>
        </p:nvSpPr>
        <p:spPr>
          <a:xfrm>
            <a:off x="2014965" y="4009967"/>
            <a:ext cx="2372737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eaLnBrk="0" fontAlgn="base" hangingPunct="0">
              <a:spcBef>
                <a:spcPct val="30000"/>
              </a:spcBef>
              <a:spcAft>
                <a:spcPct val="0"/>
              </a:spcAft>
            </a:pPr>
            <a:r>
              <a:rPr lang="en-US" altLang="en-US" sz="1050" b="1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AF peptides 113-117:</a:t>
            </a:r>
            <a:r>
              <a:rPr lang="en-US" altLang="en-US" sz="1050" b="1" dirty="0">
                <a:solidFill>
                  <a:srgbClr val="8080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a561-600</a:t>
            </a:r>
            <a:endParaRPr lang="en-US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8BDCB5C-9785-D0EE-8D00-4C07CE4F6DE6}"/>
              </a:ext>
            </a:extLst>
          </p:cNvPr>
          <p:cNvSpPr txBox="1"/>
          <p:nvPr/>
        </p:nvSpPr>
        <p:spPr>
          <a:xfrm>
            <a:off x="311440" y="6031962"/>
            <a:ext cx="6992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 (iv)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95707851-57D9-8628-CBE1-CAFB4116191F}"/>
              </a:ext>
            </a:extLst>
          </p:cNvPr>
          <p:cNvSpPr txBox="1"/>
          <p:nvPr/>
        </p:nvSpPr>
        <p:spPr>
          <a:xfrm>
            <a:off x="3133138" y="604137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7" name="Rectangle 1">
            <a:extLst>
              <a:ext uri="{FF2B5EF4-FFF2-40B4-BE49-F238E27FC236}">
                <a16:creationId xmlns:a16="http://schemas.microsoft.com/office/drawing/2014/main" id="{FCE35B09-AFBE-72B5-5AD1-D4ABB1D2DA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0854" y="6557827"/>
            <a:ext cx="2619307" cy="138499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b="1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-RAF 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S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P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b="1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b="1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en-US" sz="900" b="1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b="1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en-US" sz="900" b="1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630 [100%]</a:t>
            </a:r>
            <a:endParaRPr lang="en-US" altLang="en-US" sz="900" b="1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-RAF 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P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738 [75%] </a:t>
            </a:r>
            <a:endParaRPr lang="en-US" altLang="en-US" sz="9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RAF 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P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Q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591 [75%] </a:t>
            </a:r>
            <a:endParaRPr lang="en-US" alt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SR1 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P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H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H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W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897 [35%] </a:t>
            </a:r>
            <a:endParaRPr lang="en-US" altLang="en-US" sz="9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algn="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SR2 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P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lang="en-US" altLang="en-US" sz="900" u="sng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en-US" sz="900" u="sng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H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H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W</a:t>
            </a:r>
            <a:r>
              <a:rPr lang="en-US" altLang="en-US" sz="900" dirty="0">
                <a:solidFill>
                  <a:srgbClr val="FF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en-US" sz="900" dirty="0">
                <a:solidFill>
                  <a:srgbClr val="008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en-US" sz="900" dirty="0">
                <a:solidFill>
                  <a:srgbClr val="80808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948 [35%] </a:t>
            </a:r>
            <a:endParaRPr kumimoji="0" lang="en-US" altLang="en-US" sz="90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2K1 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E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A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WL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S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377 [0%]  </a:t>
            </a: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2K2 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E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A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WL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385 [0%]  </a:t>
            </a:r>
            <a:endParaRPr kumimoji="0" lang="en-US" altLang="en-US" sz="90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K3 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YY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E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VA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E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F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A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351 [20%] </a:t>
            </a:r>
            <a:endParaRPr kumimoji="0" lang="en-US" altLang="en-US" sz="90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PK1 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YY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E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IA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PF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80808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334 [15%] </a:t>
            </a:r>
          </a:p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           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71B8593-D700-D52F-A899-959CF894FD82}"/>
              </a:ext>
            </a:extLst>
          </p:cNvPr>
          <p:cNvSpPr txBox="1"/>
          <p:nvPr/>
        </p:nvSpPr>
        <p:spPr>
          <a:xfrm>
            <a:off x="785088" y="6264839"/>
            <a:ext cx="2372737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eaLnBrk="0" fontAlgn="base" hangingPunct="0">
              <a:spcBef>
                <a:spcPct val="30000"/>
              </a:spcBef>
              <a:spcAft>
                <a:spcPct val="0"/>
              </a:spcAft>
            </a:pPr>
            <a:r>
              <a:rPr lang="en-US" altLang="en-US" sz="1050" b="1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RAF peptides 123:</a:t>
            </a:r>
            <a:r>
              <a:rPr lang="en-US" altLang="en-US" sz="1050" b="1" dirty="0">
                <a:solidFill>
                  <a:srgbClr val="8080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a611-630</a:t>
            </a:r>
            <a:endParaRPr lang="en-US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9" name="Table 79">
            <a:extLst>
              <a:ext uri="{FF2B5EF4-FFF2-40B4-BE49-F238E27FC236}">
                <a16:creationId xmlns:a16="http://schemas.microsoft.com/office/drawing/2014/main" id="{1DC6A1C9-5450-CB68-591B-34F1DB1D85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6941887"/>
              </p:ext>
            </p:extLst>
          </p:nvPr>
        </p:nvGraphicFramePr>
        <p:xfrm>
          <a:off x="3460987" y="6260752"/>
          <a:ext cx="2884171" cy="2199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09930">
                  <a:extLst>
                    <a:ext uri="{9D8B030D-6E8A-4147-A177-3AD203B41FA5}">
                      <a16:colId xmlns:a16="http://schemas.microsoft.com/office/drawing/2014/main" val="3076761520"/>
                    </a:ext>
                  </a:extLst>
                </a:gridCol>
                <a:gridCol w="717868">
                  <a:extLst>
                    <a:ext uri="{9D8B030D-6E8A-4147-A177-3AD203B41FA5}">
                      <a16:colId xmlns:a16="http://schemas.microsoft.com/office/drawing/2014/main" val="3911546878"/>
                    </a:ext>
                  </a:extLst>
                </a:gridCol>
                <a:gridCol w="738505">
                  <a:extLst>
                    <a:ext uri="{9D8B030D-6E8A-4147-A177-3AD203B41FA5}">
                      <a16:colId xmlns:a16="http://schemas.microsoft.com/office/drawing/2014/main" val="511040626"/>
                    </a:ext>
                  </a:extLst>
                </a:gridCol>
                <a:gridCol w="717868">
                  <a:extLst>
                    <a:ext uri="{9D8B030D-6E8A-4147-A177-3AD203B41FA5}">
                      <a16:colId xmlns:a16="http://schemas.microsoft.com/office/drawing/2014/main" val="641833142"/>
                    </a:ext>
                  </a:extLst>
                </a:gridCol>
              </a:tblGrid>
              <a:tr h="145226">
                <a:tc>
                  <a:txBody>
                    <a:bodyPr/>
                    <a:lstStyle/>
                    <a:p>
                      <a:pPr algn="r"/>
                      <a:r>
                        <a:rPr lang="en-GB" sz="9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RAF </a:t>
                      </a:r>
                    </a:p>
                    <a:p>
                      <a:pPr algn="r"/>
                      <a:r>
                        <a:rPr lang="en-GB" sz="9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id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ulus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Identity]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tus 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vegicu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</a:t>
                      </a:r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ntity]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is 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pus 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iliari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 Identity]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45134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 </a:t>
                      </a:r>
                    </a:p>
                    <a:p>
                      <a:pPr algn="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31-50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96884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49</a:t>
                      </a:r>
                    </a:p>
                    <a:p>
                      <a:pPr algn="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241-260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3334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13-117</a:t>
                      </a:r>
                    </a:p>
                    <a:p>
                      <a:pPr algn="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561-600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11776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23</a:t>
                      </a:r>
                    </a:p>
                    <a:p>
                      <a:pPr algn="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611-630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28483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903050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41DF83-CFF1-209E-DF27-D250131B4B2D}"/>
              </a:ext>
            </a:extLst>
          </p:cNvPr>
          <p:cNvSpPr txBox="1"/>
          <p:nvPr/>
        </p:nvSpPr>
        <p:spPr>
          <a:xfrm>
            <a:off x="0" y="0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39B55880-E48C-54EC-D066-B24696440C80}"/>
              </a:ext>
            </a:extLst>
          </p:cNvPr>
          <p:cNvGrpSpPr/>
          <p:nvPr/>
        </p:nvGrpSpPr>
        <p:grpSpPr>
          <a:xfrm>
            <a:off x="419100" y="2739652"/>
            <a:ext cx="5838569" cy="2262795"/>
            <a:chOff x="286311" y="627297"/>
            <a:chExt cx="5979116" cy="2234874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B928C84B-A1C5-08BD-7D52-C89347756BEC}"/>
                </a:ext>
              </a:extLst>
            </p:cNvPr>
            <p:cNvGrpSpPr/>
            <p:nvPr/>
          </p:nvGrpSpPr>
          <p:grpSpPr>
            <a:xfrm>
              <a:off x="592572" y="981075"/>
              <a:ext cx="5672855" cy="1881096"/>
              <a:chOff x="640800" y="895350"/>
              <a:chExt cx="4883729" cy="1575537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6A76B322-CB22-92AE-BE5A-68B47D614E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40800" y="895350"/>
                <a:ext cx="1611314" cy="1571625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D0AC5AEA-7E5B-8502-12C9-B62C33E265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290763" y="895350"/>
                <a:ext cx="1576387" cy="1571625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67409A31-8B8C-B298-663E-6E9EEF3CD3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916556" y="895350"/>
                <a:ext cx="1607973" cy="1575537"/>
              </a:xfrm>
              <a:prstGeom prst="rect">
                <a:avLst/>
              </a:prstGeom>
            </p:spPr>
          </p:pic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FC3EDA0-7157-6FFB-59BE-B66A11CEC66B}"/>
                </a:ext>
              </a:extLst>
            </p:cNvPr>
            <p:cNvSpPr txBox="1"/>
            <p:nvPr/>
          </p:nvSpPr>
          <p:spPr>
            <a:xfrm>
              <a:off x="514538" y="636377"/>
              <a:ext cx="1147801" cy="3647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rimary Ab Only </a:t>
              </a:r>
            </a:p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(c-RAF / PDE8A)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8399502-78DC-3C48-6007-5157411B9728}"/>
                </a:ext>
              </a:extLst>
            </p:cNvPr>
            <p:cNvSpPr txBox="1"/>
            <p:nvPr/>
          </p:nvSpPr>
          <p:spPr>
            <a:xfrm rot="16200000">
              <a:off x="78498" y="1767256"/>
              <a:ext cx="692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ANC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4868024-45F8-AD6E-4B6D-5618E8EDA805}"/>
                </a:ext>
              </a:extLst>
            </p:cNvPr>
            <p:cNvSpPr txBox="1"/>
            <p:nvPr/>
          </p:nvSpPr>
          <p:spPr>
            <a:xfrm>
              <a:off x="2450614" y="627297"/>
              <a:ext cx="1121535" cy="3647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LA Probe Only</a:t>
              </a:r>
            </a:p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(No Primary Ab)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7023613-051D-2830-806D-81D83C0E2251}"/>
                </a:ext>
              </a:extLst>
            </p:cNvPr>
            <p:cNvSpPr txBox="1"/>
            <p:nvPr/>
          </p:nvSpPr>
          <p:spPr>
            <a:xfrm>
              <a:off x="4374057" y="637146"/>
              <a:ext cx="1771605" cy="3647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rimary Ab (c-RAF / PDE8A)</a:t>
              </a:r>
            </a:p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LA Probe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4CABE021-DFB0-5EEC-BDCA-31E99BD0420A}"/>
              </a:ext>
            </a:extLst>
          </p:cNvPr>
          <p:cNvSpPr txBox="1"/>
          <p:nvPr/>
        </p:nvSpPr>
        <p:spPr>
          <a:xfrm>
            <a:off x="312446" y="39921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5098CC6-05A9-3D5D-3D36-AB212637D5B6}"/>
              </a:ext>
            </a:extLst>
          </p:cNvPr>
          <p:cNvSpPr txBox="1"/>
          <p:nvPr/>
        </p:nvSpPr>
        <p:spPr>
          <a:xfrm>
            <a:off x="312446" y="5118773"/>
            <a:ext cx="5854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 (i)</a:t>
            </a:r>
          </a:p>
        </p:txBody>
      </p:sp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EB47DF42-927B-13BA-5276-521365E111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4917986"/>
              </p:ext>
            </p:extLst>
          </p:nvPr>
        </p:nvGraphicFramePr>
        <p:xfrm>
          <a:off x="4032843" y="5410739"/>
          <a:ext cx="2518296" cy="1537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2343662" imgH="1432287" progId="Prism8.Document">
                  <p:embed/>
                </p:oleObj>
              </mc:Choice>
              <mc:Fallback>
                <p:oleObj name="Prism 8" r:id="rId6" imgW="2343662" imgH="1432287" progId="Prism8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EB47DF42-927B-13BA-5276-521365E111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032843" y="5410739"/>
                        <a:ext cx="2518296" cy="1537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1" name="Group 30">
            <a:extLst>
              <a:ext uri="{FF2B5EF4-FFF2-40B4-BE49-F238E27FC236}">
                <a16:creationId xmlns:a16="http://schemas.microsoft.com/office/drawing/2014/main" id="{140487AD-A18A-B434-FDDC-378D75939F95}"/>
              </a:ext>
            </a:extLst>
          </p:cNvPr>
          <p:cNvGrpSpPr/>
          <p:nvPr/>
        </p:nvGrpSpPr>
        <p:grpSpPr>
          <a:xfrm>
            <a:off x="708637" y="5645405"/>
            <a:ext cx="3187681" cy="1537540"/>
            <a:chOff x="599816" y="5621293"/>
            <a:chExt cx="3476711" cy="1694726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16E9046B-6E2D-5639-D795-C97C7C0BD6C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366977" y="5621295"/>
              <a:ext cx="1709550" cy="1694724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2B62AB21-FFDB-822F-C67B-9F6311C77BA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99816" y="5621293"/>
              <a:ext cx="1703833" cy="1694724"/>
            </a:xfrm>
            <a:prstGeom prst="rect">
              <a:avLst/>
            </a:prstGeom>
          </p:spPr>
        </p:pic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474A8BD1-2078-9D44-CE32-2BAE42AB1DEB}"/>
              </a:ext>
            </a:extLst>
          </p:cNvPr>
          <p:cNvSpPr txBox="1"/>
          <p:nvPr/>
        </p:nvSpPr>
        <p:spPr>
          <a:xfrm rot="16200000">
            <a:off x="201587" y="6256328"/>
            <a:ext cx="701279" cy="2704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PANC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583C6BD-506E-7A2A-F982-D7A6A17BECC5}"/>
              </a:ext>
            </a:extLst>
          </p:cNvPr>
          <p:cNvSpPr txBox="1"/>
          <p:nvPr/>
        </p:nvSpPr>
        <p:spPr>
          <a:xfrm>
            <a:off x="653319" y="5421288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95BA92F-0E17-16D4-109F-9F885F0ED9B8}"/>
              </a:ext>
            </a:extLst>
          </p:cNvPr>
          <p:cNvSpPr txBox="1"/>
          <p:nvPr/>
        </p:nvSpPr>
        <p:spPr>
          <a:xfrm>
            <a:off x="2271891" y="5410759"/>
            <a:ext cx="10839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orafenib [1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794B2D1-5E14-FCCE-B5FB-5D0B5D65C03B}"/>
              </a:ext>
            </a:extLst>
          </p:cNvPr>
          <p:cNvSpPr txBox="1"/>
          <p:nvPr/>
        </p:nvSpPr>
        <p:spPr>
          <a:xfrm>
            <a:off x="4032203" y="5137823"/>
            <a:ext cx="4379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(ii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C7DE5E0-7F0D-A162-B305-5F3AB294E37B}"/>
              </a:ext>
            </a:extLst>
          </p:cNvPr>
          <p:cNvSpPr txBox="1"/>
          <p:nvPr/>
        </p:nvSpPr>
        <p:spPr>
          <a:xfrm>
            <a:off x="309820" y="26508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E24D7FD-C3DE-AC45-4189-88547A570B1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4849" y="712907"/>
            <a:ext cx="1827679" cy="190353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1F86A69-8EDC-6FB2-B743-BCEC50C86A95}"/>
              </a:ext>
            </a:extLst>
          </p:cNvPr>
          <p:cNvSpPr txBox="1"/>
          <p:nvPr/>
        </p:nvSpPr>
        <p:spPr>
          <a:xfrm>
            <a:off x="638558" y="343576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rimary Ab Only </a:t>
            </a:r>
          </a:p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-c-RAF / 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-PDE8A)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0B3C23B-5D8F-72E5-A420-7CD4BA8BB14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76873" y="712907"/>
            <a:ext cx="1823889" cy="1899868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A11373C-4DC6-C982-2B7B-41E1A792FE4E}"/>
              </a:ext>
            </a:extLst>
          </p:cNvPr>
          <p:cNvSpPr txBox="1"/>
          <p:nvPr/>
        </p:nvSpPr>
        <p:spPr>
          <a:xfrm>
            <a:off x="2508249" y="343576"/>
            <a:ext cx="1781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econdary Ab Only </a:t>
            </a:r>
          </a:p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(Alexa Fluor 488nm / 647nm) </a:t>
            </a:r>
          </a:p>
        </p:txBody>
      </p:sp>
    </p:spTree>
    <p:extLst>
      <p:ext uri="{BB962C8B-B14F-4D97-AF65-F5344CB8AC3E}">
        <p14:creationId xmlns:p14="http://schemas.microsoft.com/office/powerpoint/2010/main" val="28548404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BF5A20-25FE-7F33-9754-14E179B935A0}"/>
              </a:ext>
            </a:extLst>
          </p:cNvPr>
          <p:cNvSpPr txBox="1"/>
          <p:nvPr/>
        </p:nvSpPr>
        <p:spPr>
          <a:xfrm>
            <a:off x="0" y="0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3A4D731-8F5B-0F11-B59A-B95FD78D0A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5177088"/>
              </p:ext>
            </p:extLst>
          </p:nvPr>
        </p:nvGraphicFramePr>
        <p:xfrm>
          <a:off x="508000" y="4595813"/>
          <a:ext cx="2263775" cy="1692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094887" imgH="2311673" progId="Prism8.Document">
                  <p:embed/>
                </p:oleObj>
              </mc:Choice>
              <mc:Fallback>
                <p:oleObj name="Prism 8" r:id="rId3" imgW="3094887" imgH="2311673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3A4D731-8F5B-0F11-B59A-B95FD78D0A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8000" y="4595813"/>
                        <a:ext cx="2263775" cy="1692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EF034AC-41C0-BAC9-4C0A-3E26E05C45F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29012" y="4329555"/>
          <a:ext cx="2663825" cy="1705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3408767" imgH="2183527" progId="Prism8.Document">
                  <p:embed/>
                </p:oleObj>
              </mc:Choice>
              <mc:Fallback>
                <p:oleObj name="Prism 8" r:id="rId5" imgW="3408767" imgH="2183527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EF034AC-41C0-BAC9-4C0A-3E26E05C45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29012" y="4329555"/>
                        <a:ext cx="2663825" cy="1705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686946C-5065-1E24-3D05-C1F97B78214D}"/>
              </a:ext>
            </a:extLst>
          </p:cNvPr>
          <p:cNvSpPr txBox="1"/>
          <p:nvPr/>
        </p:nvSpPr>
        <p:spPr>
          <a:xfrm>
            <a:off x="502033" y="6146776"/>
            <a:ext cx="700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 (iii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7D40777-B527-D64B-F416-EF57ED6F5F3C}"/>
              </a:ext>
            </a:extLst>
          </p:cNvPr>
          <p:cNvSpPr txBox="1"/>
          <p:nvPr/>
        </p:nvSpPr>
        <p:spPr>
          <a:xfrm>
            <a:off x="3032316" y="6144570"/>
            <a:ext cx="698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 (iv)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69194343-9F50-8B97-8073-0F3F3E0FD1E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43300" y="6288088"/>
          <a:ext cx="2695575" cy="1793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766922" imgH="2505333" progId="Prism8.Document">
                  <p:embed/>
                </p:oleObj>
              </mc:Choice>
              <mc:Fallback>
                <p:oleObj name="Prism 8" r:id="rId7" imgW="3766922" imgH="2505333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69194343-9F50-8B97-8073-0F3F3E0FD1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43300" y="6288088"/>
                        <a:ext cx="2695575" cy="1793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8CCBFF35-CC63-08B6-0ABC-60CAE77E3B10}"/>
              </a:ext>
            </a:extLst>
          </p:cNvPr>
          <p:cNvSpPr txBox="1"/>
          <p:nvPr/>
        </p:nvSpPr>
        <p:spPr>
          <a:xfrm>
            <a:off x="498475" y="4291774"/>
            <a:ext cx="698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 (i)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9119D96-D248-B90E-4771-B34CFF4962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2677881"/>
              </p:ext>
            </p:extLst>
          </p:nvPr>
        </p:nvGraphicFramePr>
        <p:xfrm>
          <a:off x="482600" y="6408738"/>
          <a:ext cx="2392363" cy="1781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3094887" imgH="2304114" progId="Prism8.Document">
                  <p:embed/>
                </p:oleObj>
              </mc:Choice>
              <mc:Fallback>
                <p:oleObj name="Prism 8" r:id="rId9" imgW="3094887" imgH="2304114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49119D96-D248-B90E-4771-B34CFF4962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2600" y="6408738"/>
                        <a:ext cx="2392363" cy="1781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EDBA5D1D-711E-0CB2-6043-182E7F9716CB}"/>
              </a:ext>
            </a:extLst>
          </p:cNvPr>
          <p:cNvSpPr txBox="1"/>
          <p:nvPr/>
        </p:nvSpPr>
        <p:spPr>
          <a:xfrm>
            <a:off x="3032316" y="4291774"/>
            <a:ext cx="698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 (ii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F7BC588-C062-AD7D-DE85-2009D63D55EF}"/>
              </a:ext>
            </a:extLst>
          </p:cNvPr>
          <p:cNvSpPr txBox="1"/>
          <p:nvPr/>
        </p:nvSpPr>
        <p:spPr>
          <a:xfrm>
            <a:off x="498475" y="314875"/>
            <a:ext cx="698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 (i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52C60D9-CA44-6A6F-078B-C8F53CC2F03C}"/>
              </a:ext>
            </a:extLst>
          </p:cNvPr>
          <p:cNvSpPr txBox="1"/>
          <p:nvPr/>
        </p:nvSpPr>
        <p:spPr>
          <a:xfrm>
            <a:off x="3460941" y="314875"/>
            <a:ext cx="698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 (ii)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7EEEA87C-85FA-DA53-E9C8-D000E7C005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8313017"/>
              </p:ext>
            </p:extLst>
          </p:nvPr>
        </p:nvGraphicFramePr>
        <p:xfrm>
          <a:off x="411163" y="530225"/>
          <a:ext cx="3173412" cy="1811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3989373" imgH="2281077" progId="Prism8.Document">
                  <p:embed/>
                </p:oleObj>
              </mc:Choice>
              <mc:Fallback>
                <p:oleObj name="Prism 8" r:id="rId11" imgW="3989373" imgH="2281077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7EEEA87C-85FA-DA53-E9C8-D000E7C005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11163" y="530225"/>
                        <a:ext cx="3173412" cy="1811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BB1E133D-8515-CA8D-34B9-133A9C2E37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9323171"/>
              </p:ext>
            </p:extLst>
          </p:nvPr>
        </p:nvGraphicFramePr>
        <p:xfrm>
          <a:off x="3460750" y="530225"/>
          <a:ext cx="3198813" cy="180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4009171" imgH="2281077" progId="Prism8.Document">
                  <p:embed/>
                </p:oleObj>
              </mc:Choice>
              <mc:Fallback>
                <p:oleObj name="Prism 8" r:id="rId13" imgW="4009171" imgH="2281077" progId="Prism8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BB1E133D-8515-CA8D-34B9-133A9C2E37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460750" y="530225"/>
                        <a:ext cx="3198813" cy="180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2FFD06AD-07CE-6EC8-7B51-C5E653AF8E4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4500" y="2357438"/>
          <a:ext cx="3341688" cy="2065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3725887" imgH="2304114" progId="Prism8.Document">
                  <p:embed/>
                </p:oleObj>
              </mc:Choice>
              <mc:Fallback>
                <p:oleObj name="Prism 8" r:id="rId15" imgW="3725887" imgH="2304114" progId="Prism8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2FFD06AD-07CE-6EC8-7B51-C5E653AF8E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44500" y="2357438"/>
                        <a:ext cx="3341688" cy="2065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9228D803-127C-55A3-A6CC-540F05FF1E78}"/>
              </a:ext>
            </a:extLst>
          </p:cNvPr>
          <p:cNvSpPr txBox="1"/>
          <p:nvPr/>
        </p:nvSpPr>
        <p:spPr>
          <a:xfrm>
            <a:off x="498475" y="2164531"/>
            <a:ext cx="698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 (iii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18DEDB6-2A79-36F7-5B88-1218D4D13135}"/>
              </a:ext>
            </a:extLst>
          </p:cNvPr>
          <p:cNvSpPr txBox="1"/>
          <p:nvPr/>
        </p:nvSpPr>
        <p:spPr>
          <a:xfrm>
            <a:off x="3633788" y="2231425"/>
            <a:ext cx="3682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8" name="Table 18">
            <a:extLst>
              <a:ext uri="{FF2B5EF4-FFF2-40B4-BE49-F238E27FC236}">
                <a16:creationId xmlns:a16="http://schemas.microsoft.com/office/drawing/2014/main" id="{4E7148B9-E406-2204-DB7C-3FB56198FC4B}"/>
              </a:ext>
            </a:extLst>
          </p:cNvPr>
          <p:cNvGraphicFramePr>
            <a:graphicFrameLocks noGrp="1"/>
          </p:cNvGraphicFramePr>
          <p:nvPr/>
        </p:nvGraphicFramePr>
        <p:xfrm>
          <a:off x="3770310" y="2775217"/>
          <a:ext cx="2512060" cy="1112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40230">
                  <a:extLst>
                    <a:ext uri="{9D8B030D-6E8A-4147-A177-3AD203B41FA5}">
                      <a16:colId xmlns:a16="http://schemas.microsoft.com/office/drawing/2014/main" val="4158526471"/>
                    </a:ext>
                  </a:extLst>
                </a:gridCol>
                <a:gridCol w="671830">
                  <a:extLst>
                    <a:ext uri="{9D8B030D-6E8A-4147-A177-3AD203B41FA5}">
                      <a16:colId xmlns:a16="http://schemas.microsoft.com/office/drawing/2014/main" val="48173603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rofins Integrated Discovery</a:t>
                      </a:r>
                    </a:p>
                    <a:p>
                      <a:pPr algn="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 Vitro ADME Results</a:t>
                      </a:r>
                    </a:p>
                  </a:txBody>
                  <a:tcPr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x-170</a:t>
                      </a:r>
                    </a:p>
                  </a:txBody>
                  <a:tcPr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06826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 Stability, T½  </a:t>
                      </a:r>
                    </a:p>
                    <a:p>
                      <a:pPr algn="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Rat, Half-Life (min))</a:t>
                      </a:r>
                    </a:p>
                  </a:txBody>
                  <a:tcPr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0F4FA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0F4F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 180</a:t>
                      </a:r>
                    </a:p>
                  </a:txBody>
                  <a:tcPr>
                    <a:lnL w="12700" cap="flat" cmpd="sng" algn="ctr">
                      <a:solidFill>
                        <a:srgbClr val="F0F4FA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rgbClr val="F0F4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38859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 Microsome Stability</a:t>
                      </a:r>
                    </a:p>
                    <a:p>
                      <a:pPr algn="r"/>
                      <a:r>
                        <a:rPr lang="en-GB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Rat, CLint (µL/min/mg protein))</a:t>
                      </a:r>
                    </a:p>
                  </a:txBody>
                  <a:tcPr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FE8F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13.2</a:t>
                      </a:r>
                    </a:p>
                  </a:txBody>
                  <a:tcPr>
                    <a:lnL w="12700" cap="flat" cmpd="sng" algn="ctr">
                      <a:solidFill>
                        <a:srgbClr val="DFE8F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E8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8826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221737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F746B87-F990-2B84-1C12-930D1D726CC1}"/>
              </a:ext>
            </a:extLst>
          </p:cNvPr>
          <p:cNvSpPr txBox="1"/>
          <p:nvPr/>
        </p:nvSpPr>
        <p:spPr>
          <a:xfrm>
            <a:off x="-1434" y="0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3F80C7E-1121-338E-055E-B4D6B5BD0E5E}"/>
              </a:ext>
            </a:extLst>
          </p:cNvPr>
          <p:cNvSpPr txBox="1"/>
          <p:nvPr/>
        </p:nvSpPr>
        <p:spPr>
          <a:xfrm>
            <a:off x="439101" y="7655831"/>
            <a:ext cx="609366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GB" sz="1000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78A1434-9E9E-605C-339D-FF9D82A7DDA4}"/>
              </a:ext>
            </a:extLst>
          </p:cNvPr>
          <p:cNvSpPr txBox="1"/>
          <p:nvPr/>
        </p:nvSpPr>
        <p:spPr>
          <a:xfrm>
            <a:off x="686927" y="24568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7CC8DEE-5F21-5151-17D0-FAF11C6522CB}"/>
              </a:ext>
            </a:extLst>
          </p:cNvPr>
          <p:cNvSpPr txBox="1"/>
          <p:nvPr/>
        </p:nvSpPr>
        <p:spPr>
          <a:xfrm>
            <a:off x="3490805" y="24568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C6CFF32-68BC-B007-09C2-E0DB2065DE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2414922"/>
              </p:ext>
            </p:extLst>
          </p:nvPr>
        </p:nvGraphicFramePr>
        <p:xfrm>
          <a:off x="976313" y="273050"/>
          <a:ext cx="2482850" cy="1422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195314" imgH="1791889" progId="Prism8.Document">
                  <p:embed/>
                </p:oleObj>
              </mc:Choice>
              <mc:Fallback>
                <p:oleObj name="Prism 8" r:id="rId3" imgW="3195314" imgH="1791889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C6CFF32-68BC-B007-09C2-E0DB2065DE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76313" y="273050"/>
                        <a:ext cx="2482850" cy="1422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EDD93BB-206D-2E4C-89A7-D339010C2B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256326"/>
              </p:ext>
            </p:extLst>
          </p:nvPr>
        </p:nvGraphicFramePr>
        <p:xfrm>
          <a:off x="3854450" y="255588"/>
          <a:ext cx="2439988" cy="1431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3160399" imgH="1822486" progId="Prism8.Document">
                  <p:embed/>
                </p:oleObj>
              </mc:Choice>
              <mc:Fallback>
                <p:oleObj name="Prism 8" r:id="rId5" imgW="3160399" imgH="1822486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EDD93BB-206D-2E4C-89A7-D339010C2B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54450" y="255588"/>
                        <a:ext cx="2439988" cy="1431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FE69B9D4-0D92-5C18-9201-104B5EE1BA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1535169"/>
              </p:ext>
            </p:extLst>
          </p:nvPr>
        </p:nvGraphicFramePr>
        <p:xfrm>
          <a:off x="814388" y="1516063"/>
          <a:ext cx="2719387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027935" imgH="2244721" progId="Prism8.Document">
                  <p:embed/>
                </p:oleObj>
              </mc:Choice>
              <mc:Fallback>
                <p:oleObj name="Prism 8" r:id="rId7" imgW="3027935" imgH="2244721" progId="Prism8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FE69B9D4-0D92-5C18-9201-104B5EE1BA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14388" y="1516063"/>
                        <a:ext cx="2719387" cy="2016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9698A734-38EB-2EAF-8AD9-7BB209293B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9659193"/>
              </p:ext>
            </p:extLst>
          </p:nvPr>
        </p:nvGraphicFramePr>
        <p:xfrm>
          <a:off x="3657600" y="1681163"/>
          <a:ext cx="2568575" cy="1884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3020016" imgH="2080218" progId="Prism8.Document">
                  <p:embed/>
                </p:oleObj>
              </mc:Choice>
              <mc:Fallback>
                <p:oleObj name="Prism 8" r:id="rId9" imgW="3020016" imgH="2080218" progId="Prism8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9698A734-38EB-2EAF-8AD9-7BB209293B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57600" y="1681163"/>
                        <a:ext cx="2568575" cy="1884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55BF5F2E-C383-495E-9B46-82A4B67B8B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7409809"/>
              </p:ext>
            </p:extLst>
          </p:nvPr>
        </p:nvGraphicFramePr>
        <p:xfrm>
          <a:off x="885825" y="3538538"/>
          <a:ext cx="2090738" cy="180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2431851" imgH="2102896" progId="Prism8.Document">
                  <p:embed/>
                </p:oleObj>
              </mc:Choice>
              <mc:Fallback>
                <p:oleObj name="Prism 8" r:id="rId11" imgW="2431851" imgH="2102896" progId="Prism8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55BF5F2E-C383-495E-9B46-82A4B67B8B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85825" y="3538538"/>
                        <a:ext cx="2090738" cy="180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FBD41335-23B1-0D07-3F94-A5560B5389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1781054"/>
              </p:ext>
            </p:extLst>
          </p:nvPr>
        </p:nvGraphicFramePr>
        <p:xfrm>
          <a:off x="930275" y="5789613"/>
          <a:ext cx="2522538" cy="1412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3292862" imgH="1791889" progId="Prism8.Document">
                  <p:embed/>
                </p:oleObj>
              </mc:Choice>
              <mc:Fallback>
                <p:oleObj name="Prism 8" r:id="rId13" imgW="3292862" imgH="1791889" progId="Prism8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FBD41335-23B1-0D07-3F94-A5560B5389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930275" y="5789613"/>
                        <a:ext cx="2522538" cy="1412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5B921E02-E19F-1D2F-1CB7-774C55F4FA1F}"/>
              </a:ext>
            </a:extLst>
          </p:cNvPr>
          <p:cNvSpPr txBox="1"/>
          <p:nvPr/>
        </p:nvSpPr>
        <p:spPr>
          <a:xfrm>
            <a:off x="686927" y="168041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130F911-8C4F-B434-A0B0-D39CAB5B6A62}"/>
              </a:ext>
            </a:extLst>
          </p:cNvPr>
          <p:cNvSpPr txBox="1"/>
          <p:nvPr/>
        </p:nvSpPr>
        <p:spPr>
          <a:xfrm>
            <a:off x="3490805" y="163939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5A3E59C-8709-DA22-2D1F-C19FC9C1D2C3}"/>
              </a:ext>
            </a:extLst>
          </p:cNvPr>
          <p:cNvSpPr txBox="1"/>
          <p:nvPr/>
        </p:nvSpPr>
        <p:spPr>
          <a:xfrm>
            <a:off x="686927" y="352805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9D56A57-0189-BCC5-7712-A3CC62ED7AAD}"/>
              </a:ext>
            </a:extLst>
          </p:cNvPr>
          <p:cNvSpPr txBox="1"/>
          <p:nvPr/>
        </p:nvSpPr>
        <p:spPr>
          <a:xfrm>
            <a:off x="3485936" y="352344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4AB7232-9F98-FEBA-6BDA-8A7E5EBFE397}"/>
              </a:ext>
            </a:extLst>
          </p:cNvPr>
          <p:cNvSpPr txBox="1"/>
          <p:nvPr/>
        </p:nvSpPr>
        <p:spPr>
          <a:xfrm>
            <a:off x="686927" y="5628659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64A3615-D751-A371-B5F9-AC12AD4C39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6672315"/>
              </p:ext>
            </p:extLst>
          </p:nvPr>
        </p:nvGraphicFramePr>
        <p:xfrm>
          <a:off x="3534283" y="3541109"/>
          <a:ext cx="2719387" cy="222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3020016" imgH="2697192" progId="Prism8.Document">
                  <p:embed/>
                </p:oleObj>
              </mc:Choice>
              <mc:Fallback>
                <p:oleObj name="Prism 8" r:id="rId15" imgW="3020016" imgH="2697192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64A3615-D751-A371-B5F9-AC12AD4C39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534283" y="3541109"/>
                        <a:ext cx="2719387" cy="222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0F09DAF-B3A2-243A-1419-59B2FE2F69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0026021"/>
              </p:ext>
            </p:extLst>
          </p:nvPr>
        </p:nvGraphicFramePr>
        <p:xfrm>
          <a:off x="4002088" y="5765800"/>
          <a:ext cx="2074862" cy="1809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2724494" imgH="2375747" progId="Prism8.Document">
                  <p:embed/>
                </p:oleObj>
              </mc:Choice>
              <mc:Fallback>
                <p:oleObj name="Prism 8" r:id="rId17" imgW="2724494" imgH="2375747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0F09DAF-B3A2-243A-1419-59B2FE2F69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002088" y="5765800"/>
                        <a:ext cx="2074862" cy="1809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01430D5A-8E0D-DA07-32E1-D790DD0BF9B1}"/>
              </a:ext>
            </a:extLst>
          </p:cNvPr>
          <p:cNvSpPr txBox="1"/>
          <p:nvPr/>
        </p:nvSpPr>
        <p:spPr>
          <a:xfrm>
            <a:off x="3505323" y="562865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D8D23B7-1ED8-2A72-38D2-5C6F5AD5515F}"/>
              </a:ext>
            </a:extLst>
          </p:cNvPr>
          <p:cNvSpPr txBox="1"/>
          <p:nvPr/>
        </p:nvSpPr>
        <p:spPr>
          <a:xfrm>
            <a:off x="4596441" y="7463242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6.1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628DA8C-D8BB-074E-D738-1DEF9ED7354E}"/>
              </a:ext>
            </a:extLst>
          </p:cNvPr>
          <p:cNvSpPr txBox="1"/>
          <p:nvPr/>
        </p:nvSpPr>
        <p:spPr>
          <a:xfrm>
            <a:off x="4882132" y="7463242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34.7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B46693D-A727-60CB-E12E-7F457D66F831}"/>
              </a:ext>
            </a:extLst>
          </p:cNvPr>
          <p:cNvSpPr txBox="1"/>
          <p:nvPr/>
        </p:nvSpPr>
        <p:spPr>
          <a:xfrm>
            <a:off x="5203744" y="7463242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2.6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64BEF69-1E53-CC28-DE3D-6BC218AAEACE}"/>
              </a:ext>
            </a:extLst>
          </p:cNvPr>
          <p:cNvSpPr txBox="1"/>
          <p:nvPr/>
        </p:nvSpPr>
        <p:spPr>
          <a:xfrm>
            <a:off x="5509901" y="7463242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91.1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A83EBE-C5B8-1F5F-3023-EBB868F02955}"/>
              </a:ext>
            </a:extLst>
          </p:cNvPr>
          <p:cNvSpPr txBox="1"/>
          <p:nvPr/>
        </p:nvSpPr>
        <p:spPr>
          <a:xfrm>
            <a:off x="3125205" y="7458577"/>
            <a:ext cx="15905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800" b="1" dirty="0"/>
              <a:t>KRAS Mutational Prevalence (%):</a:t>
            </a:r>
          </a:p>
        </p:txBody>
      </p:sp>
    </p:spTree>
    <p:extLst>
      <p:ext uri="{BB962C8B-B14F-4D97-AF65-F5344CB8AC3E}">
        <p14:creationId xmlns:p14="http://schemas.microsoft.com/office/powerpoint/2010/main" val="10327849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F746B87-F990-2B84-1C12-930D1D726CC1}"/>
              </a:ext>
            </a:extLst>
          </p:cNvPr>
          <p:cNvSpPr txBox="1"/>
          <p:nvPr/>
        </p:nvSpPr>
        <p:spPr>
          <a:xfrm>
            <a:off x="0" y="0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graphicFrame>
        <p:nvGraphicFramePr>
          <p:cNvPr id="9" name="Table 40">
            <a:extLst>
              <a:ext uri="{FF2B5EF4-FFF2-40B4-BE49-F238E27FC236}">
                <a16:creationId xmlns:a16="http://schemas.microsoft.com/office/drawing/2014/main" id="{1748EDC5-A994-AF67-5543-3F7A24CE7E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219643"/>
              </p:ext>
            </p:extLst>
          </p:nvPr>
        </p:nvGraphicFramePr>
        <p:xfrm>
          <a:off x="732092" y="5370471"/>
          <a:ext cx="5405662" cy="264128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05011">
                  <a:extLst>
                    <a:ext uri="{9D8B030D-6E8A-4147-A177-3AD203B41FA5}">
                      <a16:colId xmlns:a16="http://schemas.microsoft.com/office/drawing/2014/main" val="3284922205"/>
                    </a:ext>
                  </a:extLst>
                </a:gridCol>
                <a:gridCol w="123543">
                  <a:extLst>
                    <a:ext uri="{9D8B030D-6E8A-4147-A177-3AD203B41FA5}">
                      <a16:colId xmlns:a16="http://schemas.microsoft.com/office/drawing/2014/main" val="182755499"/>
                    </a:ext>
                  </a:extLst>
                </a:gridCol>
                <a:gridCol w="1046084">
                  <a:extLst>
                    <a:ext uri="{9D8B030D-6E8A-4147-A177-3AD203B41FA5}">
                      <a16:colId xmlns:a16="http://schemas.microsoft.com/office/drawing/2014/main" val="1249880106"/>
                    </a:ext>
                  </a:extLst>
                </a:gridCol>
                <a:gridCol w="965512">
                  <a:extLst>
                    <a:ext uri="{9D8B030D-6E8A-4147-A177-3AD203B41FA5}">
                      <a16:colId xmlns:a16="http://schemas.microsoft.com/office/drawing/2014/main" val="751477251"/>
                    </a:ext>
                  </a:extLst>
                </a:gridCol>
                <a:gridCol w="965512">
                  <a:extLst>
                    <a:ext uri="{9D8B030D-6E8A-4147-A177-3AD203B41FA5}">
                      <a16:colId xmlns:a16="http://schemas.microsoft.com/office/drawing/2014/main" val="1021181551"/>
                    </a:ext>
                  </a:extLst>
                </a:gridCol>
              </a:tblGrid>
              <a:tr h="334041">
                <a:tc gridSpan="2">
                  <a:txBody>
                    <a:bodyPr/>
                    <a:lstStyle/>
                    <a:p>
                      <a:pPr algn="ctr"/>
                      <a:endParaRPr lang="en-GB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  <a:p>
                      <a:pPr algn="ct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ellosaurus #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C1</a:t>
                      </a:r>
                    </a:p>
                    <a:p>
                      <a:pPr algn="ct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VCL_0480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c08.13</a:t>
                      </a:r>
                    </a:p>
                    <a:p>
                      <a:pPr algn="ct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VCL_1683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0192067"/>
                  </a:ext>
                </a:extLst>
              </a:tr>
              <a:tr h="273057">
                <a:tc gridSpan="5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Pancreatic Ductal Adenocarcinoma cell lines, derived from site of primary tumour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GB" sz="7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ge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48731239"/>
                  </a:ext>
                </a:extLst>
              </a:tr>
              <a:tr h="278367">
                <a:tc rowSpan="4">
                  <a:txBody>
                    <a:bodyPr/>
                    <a:lstStyle/>
                    <a:p>
                      <a:pPr algn="r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s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: G12D</a:t>
                      </a:r>
                    </a:p>
                    <a:p>
                      <a:pPr algn="ctr"/>
                      <a:r>
                        <a:rPr lang="en-GB" sz="7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Heterozygous]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: G12D</a:t>
                      </a:r>
                    </a:p>
                    <a:p>
                      <a:pPr algn="ctr"/>
                      <a:r>
                        <a:rPr lang="en-GB" sz="7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Homozygous]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7875595"/>
                  </a:ext>
                </a:extLst>
              </a:tr>
              <a:tr h="417519">
                <a:tc vMerge="1">
                  <a:txBody>
                    <a:bodyPr/>
                    <a:lstStyle/>
                    <a:p>
                      <a:pPr algn="ctr"/>
                      <a:endParaRPr lang="en-GB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DFE8F5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53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: R273H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Homozygous]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5051060"/>
                  </a:ext>
                </a:extLst>
              </a:tr>
              <a:tr h="278367">
                <a:tc vMerge="1">
                  <a:txBody>
                    <a:bodyPr/>
                    <a:lstStyle/>
                    <a:p>
                      <a:pPr algn="ctr"/>
                      <a:endParaRPr lang="en-GB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DFE8F5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D4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: pC123f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Homozygous]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7798151"/>
                  </a:ext>
                </a:extLst>
              </a:tr>
              <a:tr h="169027">
                <a:tc vMerge="1">
                  <a:txBody>
                    <a:bodyPr/>
                    <a:lstStyle/>
                    <a:p>
                      <a:pPr algn="ctr"/>
                      <a:endParaRPr lang="en-GB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4FA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N2A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700" b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: -/-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Homozygous]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5571752"/>
                  </a:ext>
                </a:extLst>
              </a:tr>
              <a:tr h="208759">
                <a:tc rowSpan="2">
                  <a:txBody>
                    <a:bodyPr/>
                    <a:lstStyle/>
                    <a:p>
                      <a:pPr algn="r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Effect, RNAi</a:t>
                      </a:r>
                      <a:endParaRPr lang="en-GB" sz="7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chilles + DRIVE + Marcotte, DEMETER2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RAF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15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1, 56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03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1, 15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1339586"/>
                  </a:ext>
                </a:extLst>
              </a:tr>
              <a:tr h="208759">
                <a:tc vMerge="1">
                  <a:txBody>
                    <a:bodyPr/>
                    <a:lstStyle/>
                    <a:p>
                      <a:pPr algn="ctr"/>
                      <a:endParaRPr lang="en-GB" sz="7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accent1">
                          <a:lumMod val="20000"/>
                          <a:lumOff val="8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78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1, 35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14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1, 49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7665738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F4D06F58-1BA5-6F25-219D-87303183C7AD}"/>
              </a:ext>
            </a:extLst>
          </p:cNvPr>
          <p:cNvSpPr txBox="1"/>
          <p:nvPr/>
        </p:nvSpPr>
        <p:spPr>
          <a:xfrm>
            <a:off x="399949" y="41103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F6326AC-5C93-AB3C-98BD-AD3187DFFC33}"/>
              </a:ext>
            </a:extLst>
          </p:cNvPr>
          <p:cNvSpPr txBox="1"/>
          <p:nvPr/>
        </p:nvSpPr>
        <p:spPr>
          <a:xfrm>
            <a:off x="405913" y="272767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14B80B1-0533-557C-1ADC-F293187018B8}"/>
              </a:ext>
            </a:extLst>
          </p:cNvPr>
          <p:cNvSpPr txBox="1"/>
          <p:nvPr/>
        </p:nvSpPr>
        <p:spPr>
          <a:xfrm>
            <a:off x="399949" y="510530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2BA6F23-724B-7457-82A6-C62E12352F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2460572"/>
              </p:ext>
            </p:extLst>
          </p:nvPr>
        </p:nvGraphicFramePr>
        <p:xfrm>
          <a:off x="733425" y="411163"/>
          <a:ext cx="5695950" cy="2498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5695917" imgH="2499214" progId="Prism8.Document">
                  <p:embed/>
                </p:oleObj>
              </mc:Choice>
              <mc:Fallback>
                <p:oleObj name="Prism 8" r:id="rId3" imgW="5695917" imgH="2499214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2BA6F23-724B-7457-82A6-C62E12352F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33425" y="411163"/>
                        <a:ext cx="5695950" cy="2498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3D92948-31DA-9CA3-8E65-338B19F46A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2977813"/>
              </p:ext>
            </p:extLst>
          </p:nvPr>
        </p:nvGraphicFramePr>
        <p:xfrm>
          <a:off x="669925" y="2766100"/>
          <a:ext cx="5822950" cy="2498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5822621" imgH="2499214" progId="Prism8.Document">
                  <p:embed/>
                </p:oleObj>
              </mc:Choice>
              <mc:Fallback>
                <p:oleObj name="Prism 8" r:id="rId5" imgW="5822621" imgH="2499214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3D92948-31DA-9CA3-8E65-338B19F46A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69925" y="2766100"/>
                        <a:ext cx="5822950" cy="2498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74230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41DF83-CFF1-209E-DF27-D250131B4B2D}"/>
              </a:ext>
            </a:extLst>
          </p:cNvPr>
          <p:cNvSpPr txBox="1"/>
          <p:nvPr/>
        </p:nvSpPr>
        <p:spPr>
          <a:xfrm>
            <a:off x="0" y="0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F82A9A4-3EB8-97F0-78B5-907E129E59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1548875"/>
              </p:ext>
            </p:extLst>
          </p:nvPr>
        </p:nvGraphicFramePr>
        <p:xfrm>
          <a:off x="429178" y="6946216"/>
          <a:ext cx="6032218" cy="126491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01986">
                  <a:extLst>
                    <a:ext uri="{9D8B030D-6E8A-4147-A177-3AD203B41FA5}">
                      <a16:colId xmlns:a16="http://schemas.microsoft.com/office/drawing/2014/main" val="2925812442"/>
                    </a:ext>
                  </a:extLst>
                </a:gridCol>
                <a:gridCol w="777969">
                  <a:extLst>
                    <a:ext uri="{9D8B030D-6E8A-4147-A177-3AD203B41FA5}">
                      <a16:colId xmlns:a16="http://schemas.microsoft.com/office/drawing/2014/main" val="4234060929"/>
                    </a:ext>
                  </a:extLst>
                </a:gridCol>
                <a:gridCol w="123543">
                  <a:extLst>
                    <a:ext uri="{9D8B030D-6E8A-4147-A177-3AD203B41FA5}">
                      <a16:colId xmlns:a16="http://schemas.microsoft.com/office/drawing/2014/main" val="193183023"/>
                    </a:ext>
                  </a:extLst>
                </a:gridCol>
                <a:gridCol w="500474">
                  <a:extLst>
                    <a:ext uri="{9D8B030D-6E8A-4147-A177-3AD203B41FA5}">
                      <a16:colId xmlns:a16="http://schemas.microsoft.com/office/drawing/2014/main" val="125906791"/>
                    </a:ext>
                  </a:extLst>
                </a:gridCol>
                <a:gridCol w="488856">
                  <a:extLst>
                    <a:ext uri="{9D8B030D-6E8A-4147-A177-3AD203B41FA5}">
                      <a16:colId xmlns:a16="http://schemas.microsoft.com/office/drawing/2014/main" val="56735687"/>
                    </a:ext>
                  </a:extLst>
                </a:gridCol>
                <a:gridCol w="913130">
                  <a:extLst>
                    <a:ext uri="{9D8B030D-6E8A-4147-A177-3AD203B41FA5}">
                      <a16:colId xmlns:a16="http://schemas.microsoft.com/office/drawing/2014/main" val="1369051446"/>
                    </a:ext>
                  </a:extLst>
                </a:gridCol>
                <a:gridCol w="913130">
                  <a:extLst>
                    <a:ext uri="{9D8B030D-6E8A-4147-A177-3AD203B41FA5}">
                      <a16:colId xmlns:a16="http://schemas.microsoft.com/office/drawing/2014/main" val="784934059"/>
                    </a:ext>
                  </a:extLst>
                </a:gridCol>
                <a:gridCol w="913130">
                  <a:extLst>
                    <a:ext uri="{9D8B030D-6E8A-4147-A177-3AD203B41FA5}">
                      <a16:colId xmlns:a16="http://schemas.microsoft.com/office/drawing/2014/main" val="3340571943"/>
                    </a:ext>
                  </a:extLst>
                </a:gridCol>
              </a:tblGrid>
              <a:tr h="334041">
                <a:tc gridSpan="3">
                  <a:txBody>
                    <a:bodyPr/>
                    <a:lstStyle/>
                    <a:p>
                      <a:pPr algn="ctr"/>
                      <a:endParaRPr lang="en-GB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  <a:p>
                      <a:pPr algn="ct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ellosaurus #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116</a:t>
                      </a:r>
                    </a:p>
                    <a:p>
                      <a:pPr algn="ct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VCL_0291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I-H460</a:t>
                      </a:r>
                    </a:p>
                    <a:p>
                      <a:pPr algn="ct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VCL_0459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549</a:t>
                      </a:r>
                    </a:p>
                    <a:p>
                      <a:pPr algn="ct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VCL_0023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87182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lang="en-GB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GB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GB" sz="7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ge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endParaRPr lang="en-GB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1961881"/>
                  </a:ext>
                </a:extLst>
              </a:tr>
              <a:tr h="208759">
                <a:tc rowSpan="2" gridSpan="2">
                  <a:txBody>
                    <a:bodyPr/>
                    <a:lstStyle/>
                    <a:p>
                      <a:pPr algn="r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Effect, RNAi</a:t>
                      </a:r>
                      <a:endParaRPr lang="en-GB" sz="7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chilles + DRIVE + Marcotte, DEMETER2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RAF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80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1, 139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09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2, 224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15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2, 217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0590116"/>
                  </a:ext>
                </a:extLst>
              </a:tr>
              <a:tr h="0">
                <a:tc gridSpan="2" vMerge="1">
                  <a:txBody>
                    <a:bodyPr/>
                    <a:lstStyle/>
                    <a:p>
                      <a:pPr algn="ctr"/>
                      <a:endParaRPr lang="en-GB" sz="7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accent1">
                          <a:lumMod val="20000"/>
                          <a:lumOff val="8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01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1, 40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19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1, 60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91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1, 107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4423524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71AA253-E482-F539-D834-977F49D0D3A9}"/>
              </a:ext>
            </a:extLst>
          </p:cNvPr>
          <p:cNvSpPr txBox="1"/>
          <p:nvPr/>
        </p:nvSpPr>
        <p:spPr>
          <a:xfrm>
            <a:off x="3784107" y="7278554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RAS G13D</a:t>
            </a:r>
            <a:endParaRPr lang="en-GB" sz="900" baseline="30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C7462BD-B920-5C86-7949-9F1AC773D619}"/>
              </a:ext>
            </a:extLst>
          </p:cNvPr>
          <p:cNvSpPr txBox="1"/>
          <p:nvPr/>
        </p:nvSpPr>
        <p:spPr>
          <a:xfrm>
            <a:off x="4719246" y="7278554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RAS Q61H</a:t>
            </a:r>
            <a:endParaRPr lang="en-GB" sz="900" baseline="30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0F59AB3-013B-03EA-A660-F97B6E90727C}"/>
              </a:ext>
            </a:extLst>
          </p:cNvPr>
          <p:cNvSpPr txBox="1"/>
          <p:nvPr/>
        </p:nvSpPr>
        <p:spPr>
          <a:xfrm>
            <a:off x="5602955" y="7278554"/>
            <a:ext cx="8258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RAS G12S</a:t>
            </a:r>
            <a:endParaRPr lang="en-GB" sz="900" baseline="30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E7B8AF6-FC3E-4A01-609C-231EBDF51E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4750207"/>
              </p:ext>
            </p:extLst>
          </p:nvPr>
        </p:nvGraphicFramePr>
        <p:xfrm>
          <a:off x="1906587" y="386256"/>
          <a:ext cx="3044825" cy="2252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044493" imgH="2252280" progId="Prism8.Document">
                  <p:embed/>
                </p:oleObj>
              </mc:Choice>
              <mc:Fallback>
                <p:oleObj name="Prism 8" r:id="rId3" imgW="3044493" imgH="2252280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E7B8AF6-FC3E-4A01-609C-231EBDF51E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06587" y="386256"/>
                        <a:ext cx="3044825" cy="2252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FA08684C-FC91-EA00-5299-281D749E7B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7058177"/>
              </p:ext>
            </p:extLst>
          </p:nvPr>
        </p:nvGraphicFramePr>
        <p:xfrm>
          <a:off x="1906587" y="2481919"/>
          <a:ext cx="3062287" cy="2252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3062851" imgH="2252280" progId="Prism8.Document">
                  <p:embed/>
                </p:oleObj>
              </mc:Choice>
              <mc:Fallback>
                <p:oleObj name="Prism 8" r:id="rId5" imgW="3062851" imgH="2252280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FA08684C-FC91-EA00-5299-281D749E7B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06587" y="2481919"/>
                        <a:ext cx="3062287" cy="2252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E34A632A-EC7C-E862-7D39-0BA587A636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9034551"/>
              </p:ext>
            </p:extLst>
          </p:nvPr>
        </p:nvGraphicFramePr>
        <p:xfrm>
          <a:off x="1906587" y="4578229"/>
          <a:ext cx="3035300" cy="2252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035494" imgH="2252280" progId="Prism8.Document">
                  <p:embed/>
                </p:oleObj>
              </mc:Choice>
              <mc:Fallback>
                <p:oleObj name="Prism 8" r:id="rId7" imgW="3035494" imgH="2252280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E34A632A-EC7C-E862-7D39-0BA587A636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06587" y="4578229"/>
                        <a:ext cx="3035300" cy="2252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CB53E6DB-9F6C-DE54-A1C2-6132266CBE21}"/>
              </a:ext>
            </a:extLst>
          </p:cNvPr>
          <p:cNvSpPr txBox="1"/>
          <p:nvPr/>
        </p:nvSpPr>
        <p:spPr>
          <a:xfrm>
            <a:off x="1556983" y="38625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BA4A28-5268-06B2-666C-622EA48CED63}"/>
              </a:ext>
            </a:extLst>
          </p:cNvPr>
          <p:cNvSpPr txBox="1"/>
          <p:nvPr/>
        </p:nvSpPr>
        <p:spPr>
          <a:xfrm>
            <a:off x="1556983" y="246964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6210F5-DF68-3185-FA9B-292641BCA3C9}"/>
              </a:ext>
            </a:extLst>
          </p:cNvPr>
          <p:cNvSpPr txBox="1"/>
          <p:nvPr/>
        </p:nvSpPr>
        <p:spPr>
          <a:xfrm>
            <a:off x="1547458" y="457822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F951902-992F-1600-8459-809019F9D36D}"/>
              </a:ext>
            </a:extLst>
          </p:cNvPr>
          <p:cNvSpPr txBox="1"/>
          <p:nvPr/>
        </p:nvSpPr>
        <p:spPr>
          <a:xfrm>
            <a:off x="263107" y="654278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7056413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41DF83-CFF1-209E-DF27-D250131B4B2D}"/>
              </a:ext>
            </a:extLst>
          </p:cNvPr>
          <p:cNvSpPr txBox="1"/>
          <p:nvPr/>
        </p:nvSpPr>
        <p:spPr>
          <a:xfrm>
            <a:off x="0" y="0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DB01CD5-F30C-CF7D-78A2-DBF4CCF1C9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8317328"/>
              </p:ext>
            </p:extLst>
          </p:nvPr>
        </p:nvGraphicFramePr>
        <p:xfrm>
          <a:off x="1669593" y="516841"/>
          <a:ext cx="3049588" cy="2289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049173" imgH="2288636" progId="Prism8.Document">
                  <p:embed/>
                </p:oleObj>
              </mc:Choice>
              <mc:Fallback>
                <p:oleObj name="Prism 8" r:id="rId3" imgW="3049173" imgH="2288636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DB01CD5-F30C-CF7D-78A2-DBF4CCF1C9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69593" y="516841"/>
                        <a:ext cx="3049588" cy="2289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F82A9A4-3EB8-97F0-78B5-907E129E59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4717595"/>
              </p:ext>
            </p:extLst>
          </p:nvPr>
        </p:nvGraphicFramePr>
        <p:xfrm>
          <a:off x="1326021" y="2900801"/>
          <a:ext cx="4205958" cy="126491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79955">
                  <a:extLst>
                    <a:ext uri="{9D8B030D-6E8A-4147-A177-3AD203B41FA5}">
                      <a16:colId xmlns:a16="http://schemas.microsoft.com/office/drawing/2014/main" val="2925812442"/>
                    </a:ext>
                  </a:extLst>
                </a:gridCol>
                <a:gridCol w="123543">
                  <a:extLst>
                    <a:ext uri="{9D8B030D-6E8A-4147-A177-3AD203B41FA5}">
                      <a16:colId xmlns:a16="http://schemas.microsoft.com/office/drawing/2014/main" val="193183023"/>
                    </a:ext>
                  </a:extLst>
                </a:gridCol>
                <a:gridCol w="989330">
                  <a:extLst>
                    <a:ext uri="{9D8B030D-6E8A-4147-A177-3AD203B41FA5}">
                      <a16:colId xmlns:a16="http://schemas.microsoft.com/office/drawing/2014/main" val="125906791"/>
                    </a:ext>
                  </a:extLst>
                </a:gridCol>
                <a:gridCol w="913130">
                  <a:extLst>
                    <a:ext uri="{9D8B030D-6E8A-4147-A177-3AD203B41FA5}">
                      <a16:colId xmlns:a16="http://schemas.microsoft.com/office/drawing/2014/main" val="1369051446"/>
                    </a:ext>
                  </a:extLst>
                </a:gridCol>
              </a:tblGrid>
              <a:tr h="334041">
                <a:tc gridSpan="2">
                  <a:txBody>
                    <a:bodyPr/>
                    <a:lstStyle/>
                    <a:p>
                      <a:pPr algn="ctr"/>
                      <a:endParaRPr lang="en-GB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F2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  <a:p>
                      <a:pPr algn="ct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ellosaurus #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2-OS</a:t>
                      </a:r>
                    </a:p>
                    <a:p>
                      <a:pPr algn="ctr"/>
                      <a:r>
                        <a:rPr lang="en-GB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VCL_0042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871824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/>
                      <a:endParaRPr lang="en-GB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GB" sz="7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ge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1961881"/>
                  </a:ext>
                </a:extLst>
              </a:tr>
              <a:tr h="208759">
                <a:tc rowSpan="2">
                  <a:txBody>
                    <a:bodyPr/>
                    <a:lstStyle/>
                    <a:p>
                      <a:pPr algn="r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Effect, RNAi</a:t>
                      </a:r>
                      <a:endParaRPr lang="en-GB" sz="7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chilles + DRIVE + Marcotte, DEMETER2)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RAF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79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2, 278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059011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/>
                      <a:endParaRPr lang="en-GB" sz="7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accent1">
                          <a:lumMod val="20000"/>
                          <a:lumOff val="8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1</a:t>
                      </a:r>
                    </a:p>
                    <a:p>
                      <a:pPr algn="ctr"/>
                      <a:r>
                        <a:rPr lang="en-GB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Q3, 606 / 666]</a:t>
                      </a:r>
                    </a:p>
                  </a:txBody>
                  <a:tcPr marT="45719" marB="45719" anchor="ctr">
                    <a:lnL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206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4423524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68BEB47-DDD4-F3FD-A253-A13E28FE38BE}"/>
              </a:ext>
            </a:extLst>
          </p:cNvPr>
          <p:cNvSpPr txBox="1"/>
          <p:nvPr/>
        </p:nvSpPr>
        <p:spPr>
          <a:xfrm>
            <a:off x="4693781" y="3248936"/>
            <a:ext cx="80983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-RAF</a:t>
            </a:r>
            <a:r>
              <a:rPr lang="en-US" sz="900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900" baseline="30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8895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7ed581de-19d2-466c-8863-622701b259f0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92876437B99B04CA0A0259AFDABB09E" ma:contentTypeVersion="11" ma:contentTypeDescription="Create a new document." ma:contentTypeScope="" ma:versionID="5f92f623b194baab12083c9e87ae1dd4">
  <xsd:schema xmlns:xsd="http://www.w3.org/2001/XMLSchema" xmlns:xs="http://www.w3.org/2001/XMLSchema" xmlns:p="http://schemas.microsoft.com/office/2006/metadata/properties" xmlns:ns3="7ed581de-19d2-466c-8863-622701b259f0" targetNamespace="http://schemas.microsoft.com/office/2006/metadata/properties" ma:root="true" ma:fieldsID="3b9aff6c227436546e1c51eaca58eed3" ns3:_="">
    <xsd:import namespace="7ed581de-19d2-466c-8863-622701b259f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ed581de-19d2-466c-8863-622701b259f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18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596599E-5933-4433-9E6C-7B72544BD27B}">
  <ds:schemaRefs>
    <ds:schemaRef ds:uri="7ed581de-19d2-466c-8863-622701b259f0"/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purl.org/dc/terms/"/>
    <ds:schemaRef ds:uri="http://www.w3.org/XML/1998/namespace"/>
    <ds:schemaRef ds:uri="http://schemas.microsoft.com/office/infopath/2007/PartnerControls"/>
    <ds:schemaRef ds:uri="http://schemas.openxmlformats.org/package/2006/metadata/core-properties"/>
  </ds:schemaRefs>
</ds:datastoreItem>
</file>

<file path=customXml/itemProps2.xml><?xml version="1.0" encoding="utf-8"?>
<ds:datastoreItem xmlns:ds="http://schemas.openxmlformats.org/officeDocument/2006/customXml" ds:itemID="{50EAC490-FE8F-4FEA-B915-629F922CE25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DAF203C-8A99-47B2-9199-967E1A97F36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ed581de-19d2-466c-8863-622701b259f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0669</TotalTime>
  <Words>2124</Words>
  <Application>Microsoft Office PowerPoint</Application>
  <PresentationFormat>A4 Paper (210x297 mm)</PresentationFormat>
  <Paragraphs>253</Paragraphs>
  <Slides>8</Slides>
  <Notes>8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Courier New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r Blair</dc:creator>
  <cp:lastModifiedBy>Connor Blair</cp:lastModifiedBy>
  <cp:revision>24</cp:revision>
  <dcterms:created xsi:type="dcterms:W3CDTF">2023-03-15T09:52:16Z</dcterms:created>
  <dcterms:modified xsi:type="dcterms:W3CDTF">2024-03-14T17:49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92876437B99B04CA0A0259AFDABB09E</vt:lpwstr>
  </property>
</Properties>
</file>